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4"/>
  </p:notesMasterIdLst>
  <p:sldIdLst>
    <p:sldId id="266" r:id="rId2"/>
    <p:sldId id="267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B67F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22A9A484-E00C-8D4C-A0A2-D8BC77375D97}" v="265" dt="2024-03-04T07:06:23.83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196"/>
    <p:restoredTop sz="94862"/>
  </p:normalViewPr>
  <p:slideViewPr>
    <p:cSldViewPr snapToGrid="0">
      <p:cViewPr varScale="1">
        <p:scale>
          <a:sx n="49" d="100"/>
          <a:sy n="49" d="100"/>
        </p:scale>
        <p:origin x="211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notesMaster" Target="notesMasters/notesMaster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Elliott, Andrew" userId="57170054-896e-4a7b-99a2-5f2f342d2a77" providerId="ADAL" clId="{22A9A484-E00C-8D4C-A0A2-D8BC77375D97}"/>
    <pc:docChg chg="undo redo custSel addSld modSld">
      <pc:chgData name="Elliott, Andrew" userId="57170054-896e-4a7b-99a2-5f2f342d2a77" providerId="ADAL" clId="{22A9A484-E00C-8D4C-A0A2-D8BC77375D97}" dt="2024-03-04T07:06:35.597" v="2802" actId="478"/>
      <pc:docMkLst>
        <pc:docMk/>
      </pc:docMkLst>
      <pc:sldChg chg="addSp delSp modSp mod">
        <pc:chgData name="Elliott, Andrew" userId="57170054-896e-4a7b-99a2-5f2f342d2a77" providerId="ADAL" clId="{22A9A484-E00C-8D4C-A0A2-D8BC77375D97}" dt="2024-03-04T06:12:33.244" v="1710" actId="1035"/>
        <pc:sldMkLst>
          <pc:docMk/>
          <pc:sldMk cId="956311682" sldId="256"/>
        </pc:sldMkLst>
        <pc:spChg chg="mod">
          <ac:chgData name="Elliott, Andrew" userId="57170054-896e-4a7b-99a2-5f2f342d2a77" providerId="ADAL" clId="{22A9A484-E00C-8D4C-A0A2-D8BC77375D97}" dt="2024-02-28T16:28:11.873" v="405" actId="20577"/>
          <ac:spMkLst>
            <pc:docMk/>
            <pc:sldMk cId="956311682" sldId="256"/>
            <ac:spMk id="3" creationId="{EBBE5B98-10F9-A09C-F2D3-C551D1C393A6}"/>
          </ac:spMkLst>
        </pc:spChg>
        <pc:spChg chg="add mod">
          <ac:chgData name="Elliott, Andrew" userId="57170054-896e-4a7b-99a2-5f2f342d2a77" providerId="ADAL" clId="{22A9A484-E00C-8D4C-A0A2-D8BC77375D97}" dt="2024-03-04T06:11:59.115" v="1693" actId="6549"/>
          <ac:spMkLst>
            <pc:docMk/>
            <pc:sldMk cId="956311682" sldId="256"/>
            <ac:spMk id="4" creationId="{2F8DF727-E3E0-5B8B-5652-FEDEFDF8A9E1}"/>
          </ac:spMkLst>
        </pc:spChg>
        <pc:picChg chg="del">
          <ac:chgData name="Elliott, Andrew" userId="57170054-896e-4a7b-99a2-5f2f342d2a77" providerId="ADAL" clId="{22A9A484-E00C-8D4C-A0A2-D8BC77375D97}" dt="2024-03-04T06:12:17.987" v="1695" actId="478"/>
          <ac:picMkLst>
            <pc:docMk/>
            <pc:sldMk cId="956311682" sldId="256"/>
            <ac:picMk id="2" creationId="{5C6F5360-570A-9538-926A-5716391680D4}"/>
          </ac:picMkLst>
        </pc:picChg>
        <pc:picChg chg="add">
          <ac:chgData name="Elliott, Andrew" userId="57170054-896e-4a7b-99a2-5f2f342d2a77" providerId="ADAL" clId="{22A9A484-E00C-8D4C-A0A2-D8BC77375D97}" dt="2024-03-04T06:11:57.739" v="1691"/>
          <ac:picMkLst>
            <pc:docMk/>
            <pc:sldMk cId="956311682" sldId="256"/>
            <ac:picMk id="7" creationId="{70E568D0-6178-DCB9-02D8-9E6E51D65EDE}"/>
          </ac:picMkLst>
        </pc:picChg>
        <pc:picChg chg="add mod">
          <ac:chgData name="Elliott, Andrew" userId="57170054-896e-4a7b-99a2-5f2f342d2a77" providerId="ADAL" clId="{22A9A484-E00C-8D4C-A0A2-D8BC77375D97}" dt="2024-03-04T06:12:33.244" v="1710" actId="1035"/>
          <ac:picMkLst>
            <pc:docMk/>
            <pc:sldMk cId="956311682" sldId="256"/>
            <ac:picMk id="8" creationId="{6ACC8BA7-34FB-D216-2FC5-F9728F5B9584}"/>
          </ac:picMkLst>
        </pc:picChg>
      </pc:sldChg>
      <pc:sldChg chg="addSp delSp modSp mod">
        <pc:chgData name="Elliott, Andrew" userId="57170054-896e-4a7b-99a2-5f2f342d2a77" providerId="ADAL" clId="{22A9A484-E00C-8D4C-A0A2-D8BC77375D97}" dt="2024-03-04T06:26:37.023" v="1936" actId="478"/>
        <pc:sldMkLst>
          <pc:docMk/>
          <pc:sldMk cId="332806350" sldId="262"/>
        </pc:sldMkLst>
        <pc:spChg chg="add del mod">
          <ac:chgData name="Elliott, Andrew" userId="57170054-896e-4a7b-99a2-5f2f342d2a77" providerId="ADAL" clId="{22A9A484-E00C-8D4C-A0A2-D8BC77375D97}" dt="2024-02-29T06:31:08.507" v="1400" actId="21"/>
          <ac:spMkLst>
            <pc:docMk/>
            <pc:sldMk cId="332806350" sldId="262"/>
            <ac:spMk id="19" creationId="{23C8F078-4B5A-7AFA-4FF2-14C79049AD06}"/>
          </ac:spMkLst>
        </pc:spChg>
        <pc:spChg chg="add del">
          <ac:chgData name="Elliott, Andrew" userId="57170054-896e-4a7b-99a2-5f2f342d2a77" providerId="ADAL" clId="{22A9A484-E00C-8D4C-A0A2-D8BC77375D97}" dt="2024-02-29T06:31:03.333" v="1398" actId="21"/>
          <ac:spMkLst>
            <pc:docMk/>
            <pc:sldMk cId="332806350" sldId="262"/>
            <ac:spMk id="91" creationId="{EB6564EA-ABC1-AAC8-01B6-5293DD6620A2}"/>
          </ac:spMkLst>
        </pc:spChg>
        <pc:spChg chg="add del mod">
          <ac:chgData name="Elliott, Andrew" userId="57170054-896e-4a7b-99a2-5f2f342d2a77" providerId="ADAL" clId="{22A9A484-E00C-8D4C-A0A2-D8BC77375D97}" dt="2024-03-04T06:26:37.023" v="1936" actId="478"/>
          <ac:spMkLst>
            <pc:docMk/>
            <pc:sldMk cId="332806350" sldId="262"/>
            <ac:spMk id="103" creationId="{6FE852D1-FE1A-2863-1930-8D64338C9F20}"/>
          </ac:spMkLst>
        </pc:spChg>
        <pc:spChg chg="add del">
          <ac:chgData name="Elliott, Andrew" userId="57170054-896e-4a7b-99a2-5f2f342d2a77" providerId="ADAL" clId="{22A9A484-E00C-8D4C-A0A2-D8BC77375D97}" dt="2024-03-04T06:26:31.275" v="1931" actId="478"/>
          <ac:spMkLst>
            <pc:docMk/>
            <pc:sldMk cId="332806350" sldId="262"/>
            <ac:spMk id="125" creationId="{35D1E07D-5F7A-A90E-AD4C-21EA03188F8F}"/>
          </ac:spMkLst>
        </pc:spChg>
        <pc:spChg chg="add del mod">
          <ac:chgData name="Elliott, Andrew" userId="57170054-896e-4a7b-99a2-5f2f342d2a77" providerId="ADAL" clId="{22A9A484-E00C-8D4C-A0A2-D8BC77375D97}" dt="2024-03-04T06:26:30.964" v="1930" actId="478"/>
          <ac:spMkLst>
            <pc:docMk/>
            <pc:sldMk cId="332806350" sldId="262"/>
            <ac:spMk id="156" creationId="{B60AB3C6-52A0-4F70-93D8-6B3E56A21C00}"/>
          </ac:spMkLst>
        </pc:spChg>
        <pc:grpChg chg="mod">
          <ac:chgData name="Elliott, Andrew" userId="57170054-896e-4a7b-99a2-5f2f342d2a77" providerId="ADAL" clId="{22A9A484-E00C-8D4C-A0A2-D8BC77375D97}" dt="2024-03-04T06:26:37.023" v="1936" actId="478"/>
          <ac:grpSpMkLst>
            <pc:docMk/>
            <pc:sldMk cId="332806350" sldId="262"/>
            <ac:grpSpMk id="101" creationId="{6463FCED-B3C7-D449-2ED1-EE7912022E06}"/>
          </ac:grpSpMkLst>
        </pc:grpChg>
        <pc:grpChg chg="add del">
          <ac:chgData name="Elliott, Andrew" userId="57170054-896e-4a7b-99a2-5f2f342d2a77" providerId="ADAL" clId="{22A9A484-E00C-8D4C-A0A2-D8BC77375D97}" dt="2024-03-04T06:26:37.023" v="1936" actId="478"/>
          <ac:grpSpMkLst>
            <pc:docMk/>
            <pc:sldMk cId="332806350" sldId="262"/>
            <ac:grpSpMk id="106" creationId="{046C4518-078D-2198-18CF-B5F1261229BA}"/>
          </ac:grpSpMkLst>
        </pc:grpChg>
        <pc:grpChg chg="add del">
          <ac:chgData name="Elliott, Andrew" userId="57170054-896e-4a7b-99a2-5f2f342d2a77" providerId="ADAL" clId="{22A9A484-E00C-8D4C-A0A2-D8BC77375D97}" dt="2024-02-29T06:31:03.333" v="1398" actId="21"/>
          <ac:grpSpMkLst>
            <pc:docMk/>
            <pc:sldMk cId="332806350" sldId="262"/>
            <ac:grpSpMk id="124" creationId="{B92CA583-E4CA-5CA0-B7A7-1A1F15394AB9}"/>
          </ac:grpSpMkLst>
        </pc:grpChg>
        <pc:grpChg chg="add del">
          <ac:chgData name="Elliott, Andrew" userId="57170054-896e-4a7b-99a2-5f2f342d2a77" providerId="ADAL" clId="{22A9A484-E00C-8D4C-A0A2-D8BC77375D97}" dt="2024-03-04T06:26:31.275" v="1931" actId="478"/>
          <ac:grpSpMkLst>
            <pc:docMk/>
            <pc:sldMk cId="332806350" sldId="262"/>
            <ac:grpSpMk id="129" creationId="{28533A36-655B-788E-0EAE-2F90DF499988}"/>
          </ac:grpSpMkLst>
        </pc:grpChg>
        <pc:grpChg chg="mod">
          <ac:chgData name="Elliott, Andrew" userId="57170054-896e-4a7b-99a2-5f2f342d2a77" providerId="ADAL" clId="{22A9A484-E00C-8D4C-A0A2-D8BC77375D97}" dt="2024-03-04T06:26:30.964" v="1930" actId="478"/>
          <ac:grpSpMkLst>
            <pc:docMk/>
            <pc:sldMk cId="332806350" sldId="262"/>
            <ac:grpSpMk id="142" creationId="{3E26E31E-62F5-6F70-C13D-C0E30AB90E24}"/>
          </ac:grpSpMkLst>
        </pc:grpChg>
        <pc:grpChg chg="add del">
          <ac:chgData name="Elliott, Andrew" userId="57170054-896e-4a7b-99a2-5f2f342d2a77" providerId="ADAL" clId="{22A9A484-E00C-8D4C-A0A2-D8BC77375D97}" dt="2024-03-04T06:26:30.964" v="1930" actId="478"/>
          <ac:grpSpMkLst>
            <pc:docMk/>
            <pc:sldMk cId="332806350" sldId="262"/>
            <ac:grpSpMk id="157" creationId="{C7EEC0FE-CB8C-E8D5-0FF2-4BEF39B26065}"/>
          </ac:grpSpMkLst>
        </pc:grpChg>
        <pc:graphicFrameChg chg="add del mod">
          <ac:chgData name="Elliott, Andrew" userId="57170054-896e-4a7b-99a2-5f2f342d2a77" providerId="ADAL" clId="{22A9A484-E00C-8D4C-A0A2-D8BC77375D97}" dt="2024-02-28T22:54:19.542" v="522" actId="21"/>
          <ac:graphicFrameMkLst>
            <pc:docMk/>
            <pc:sldMk cId="332806350" sldId="262"/>
            <ac:graphicFrameMk id="2" creationId="{668B30DD-ED11-C647-A45E-50EFD577B3F0}"/>
          </ac:graphicFrameMkLst>
        </pc:graphicFrameChg>
      </pc:sldChg>
      <pc:sldChg chg="addSp delSp modSp mod">
        <pc:chgData name="Elliott, Andrew" userId="57170054-896e-4a7b-99a2-5f2f342d2a77" providerId="ADAL" clId="{22A9A484-E00C-8D4C-A0A2-D8BC77375D97}" dt="2024-03-04T07:06:35.597" v="2802" actId="478"/>
        <pc:sldMkLst>
          <pc:docMk/>
          <pc:sldMk cId="1371429643" sldId="263"/>
        </pc:sldMkLst>
        <pc:spChg chg="add del mod">
          <ac:chgData name="Elliott, Andrew" userId="57170054-896e-4a7b-99a2-5f2f342d2a77" providerId="ADAL" clId="{22A9A484-E00C-8D4C-A0A2-D8BC77375D97}" dt="2024-03-04T06:20:40.807" v="1761" actId="478"/>
          <ac:spMkLst>
            <pc:docMk/>
            <pc:sldMk cId="1371429643" sldId="263"/>
            <ac:spMk id="3" creationId="{66213FC4-61A8-AA17-39DE-D2760B862706}"/>
          </ac:spMkLst>
        </pc:spChg>
        <pc:spChg chg="mod">
          <ac:chgData name="Elliott, Andrew" userId="57170054-896e-4a7b-99a2-5f2f342d2a77" providerId="ADAL" clId="{22A9A484-E00C-8D4C-A0A2-D8BC77375D97}" dt="2024-03-04T06:19:46.428" v="1722" actId="1076"/>
          <ac:spMkLst>
            <pc:docMk/>
            <pc:sldMk cId="1371429643" sldId="263"/>
            <ac:spMk id="4" creationId="{9E7340E7-BC77-BCBD-86AB-ED1F3377741C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6" creationId="{814BBE4B-B889-083A-B30A-0A4824BEED36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" creationId="{5F511838-D3B1-9B3E-5164-E58908EDAB2E}"/>
          </ac:spMkLst>
        </pc:spChg>
        <pc:spChg chg="del mod topLvl">
          <ac:chgData name="Elliott, Andrew" userId="57170054-896e-4a7b-99a2-5f2f342d2a77" providerId="ADAL" clId="{22A9A484-E00C-8D4C-A0A2-D8BC77375D97}" dt="2024-02-28T23:05:48.849" v="782" actId="478"/>
          <ac:spMkLst>
            <pc:docMk/>
            <pc:sldMk cId="1371429643" sldId="263"/>
            <ac:spMk id="7" creationId="{E92D64B5-BC3E-D188-0FC7-523D8DFEAA20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8" creationId="{52AFBDE9-28D0-7217-E252-A9E48BC2BD2B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9" creationId="{1017470B-B9FA-8D9D-1CF9-B1EECEBD32FD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0" creationId="{45240314-C698-9712-0351-00FFF52AB1BA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1" creationId="{85F0A210-9553-BF76-E522-AC6C82E36ADE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2" creationId="{0E57B0B3-5F6B-128C-D6BA-2D2BF27D0C78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3" creationId="{C7A1DCE4-16C7-6160-F1C8-54A717248ACF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4" creationId="{D60293D2-C806-56DF-69EC-A3A3160DFA1D}"/>
          </ac:spMkLst>
        </pc:spChg>
        <pc:spChg chg="mod">
          <ac:chgData name="Elliott, Andrew" userId="57170054-896e-4a7b-99a2-5f2f342d2a77" providerId="ADAL" clId="{22A9A484-E00C-8D4C-A0A2-D8BC77375D97}" dt="2024-03-04T06:20:24.010" v="1750" actId="1035"/>
          <ac:spMkLst>
            <pc:docMk/>
            <pc:sldMk cId="1371429643" sldId="263"/>
            <ac:spMk id="15" creationId="{9CFDBAE6-F26B-9E22-232C-3EB32E507651}"/>
          </ac:spMkLst>
        </pc:spChg>
        <pc:spChg chg="mod">
          <ac:chgData name="Elliott, Andrew" userId="57170054-896e-4a7b-99a2-5f2f342d2a77" providerId="ADAL" clId="{22A9A484-E00C-8D4C-A0A2-D8BC77375D97}" dt="2024-03-04T06:20:45.867" v="1766" actId="1035"/>
          <ac:spMkLst>
            <pc:docMk/>
            <pc:sldMk cId="1371429643" sldId="263"/>
            <ac:spMk id="16" creationId="{3513699C-F8BD-4AC4-69D5-300FA333AF19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7" creationId="{66C1DC46-F416-A301-25B8-722A4227B6DC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8" creationId="{E8F96FFE-E542-C4DA-AD3B-C7E34EA0730C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19" creationId="{A495FEA2-37BA-C755-AB3C-5B4613CA07CB}"/>
          </ac:spMkLst>
        </pc:spChg>
        <pc:spChg chg="del mod topLvl">
          <ac:chgData name="Elliott, Andrew" userId="57170054-896e-4a7b-99a2-5f2f342d2a77" providerId="ADAL" clId="{22A9A484-E00C-8D4C-A0A2-D8BC77375D97}" dt="2024-02-28T22:58:45.721" v="599" actId="478"/>
          <ac:spMkLst>
            <pc:docMk/>
            <pc:sldMk cId="1371429643" sldId="263"/>
            <ac:spMk id="20" creationId="{3E0C3483-B3BC-2558-8B85-F3A6B664F485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20" creationId="{7C428D6A-BB70-EB50-3427-9D0716A1F361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1" creationId="{6F62AC6A-C7D7-6310-00E0-2B7921535337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2" creationId="{8E608B70-A231-CD03-0753-1A2CA6D7A5BD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3" creationId="{7A7B2A0B-8DBE-B4D6-B074-4F97BFE56EC4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4" creationId="{815C70B9-7576-C231-0794-64D8322588A8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5" creationId="{2BEB48BA-6FFE-9CAC-1BFB-52B5A230A231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6" creationId="{DA6E2881-7933-D5DB-21D3-97339999D7F7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8" creationId="{F24B2566-FF53-CC2C-B52D-983BB978FF1A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29" creationId="{CD2146B8-F96B-E8CE-E160-15EE9B1F18B7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30" creationId="{C5BD2C64-9730-662A-8EB2-946ADE0D48CC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31" creationId="{18328447-2CF7-F6BE-9291-A4D50D40EC29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32" creationId="{93B7E740-C2C2-20EF-9B07-F3B7EF526AE0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33" creationId="{22F1FD6F-E01A-82BF-C2A9-B1DB96B0AC8E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34" creationId="{AA03AE13-D0EE-90B6-E042-72CE7528C6C1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35" creationId="{4D7EC070-94D4-E411-5EF0-DD111613AF63}"/>
          </ac:spMkLst>
        </pc:spChg>
        <pc:spChg chg="mod topLvl">
          <ac:chgData name="Elliott, Andrew" userId="57170054-896e-4a7b-99a2-5f2f342d2a77" providerId="ADAL" clId="{22A9A484-E00C-8D4C-A0A2-D8BC77375D97}" dt="2024-03-04T06:20:37.444" v="1759" actId="1035"/>
          <ac:spMkLst>
            <pc:docMk/>
            <pc:sldMk cId="1371429643" sldId="263"/>
            <ac:spMk id="36" creationId="{B6737654-9A6B-B1FA-874F-D0C0C3E0D5B9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37" creationId="{381D9889-5550-D517-0EB8-D1D090079913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38" creationId="{711E1BF4-0E32-5E25-A42B-8E3FB576A75B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39" creationId="{8ECB367E-B32B-1115-5BE5-05583FB9DBE8}"/>
          </ac:spMkLst>
        </pc:spChg>
        <pc:spChg chg="add">
          <ac:chgData name="Elliott, Andrew" userId="57170054-896e-4a7b-99a2-5f2f342d2a77" providerId="ADAL" clId="{22A9A484-E00C-8D4C-A0A2-D8BC77375D97}" dt="2024-02-28T23:12:53.936" v="822"/>
          <ac:spMkLst>
            <pc:docMk/>
            <pc:sldMk cId="1371429643" sldId="263"/>
            <ac:spMk id="40" creationId="{080C3F0A-9860-5BC4-960D-E215CE61A671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0" creationId="{41DF2187-C0B5-A44E-D638-C982A5A48209}"/>
          </ac:spMkLst>
        </pc:spChg>
        <pc:spChg chg="add del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1" creationId="{B2FEF2E6-3F74-176D-E8AB-7BE2C11BE746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2" creationId="{B7EA2A99-4D2F-AECB-87AB-9C85EB8B43F5}"/>
          </ac:spMkLst>
        </pc:spChg>
        <pc:spChg chg="add">
          <ac:chgData name="Elliott, Andrew" userId="57170054-896e-4a7b-99a2-5f2f342d2a77" providerId="ADAL" clId="{22A9A484-E00C-8D4C-A0A2-D8BC77375D97}" dt="2024-02-28T23:13:08.988" v="826"/>
          <ac:spMkLst>
            <pc:docMk/>
            <pc:sldMk cId="1371429643" sldId="263"/>
            <ac:spMk id="42" creationId="{D207CA92-2CB8-0514-84D8-DD48C076C977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3" creationId="{77AD2E77-FCE6-4BEE-81BD-91E40658A823}"/>
          </ac:spMkLst>
        </pc:spChg>
        <pc:spChg chg="add del">
          <ac:chgData name="Elliott, Andrew" userId="57170054-896e-4a7b-99a2-5f2f342d2a77" providerId="ADAL" clId="{22A9A484-E00C-8D4C-A0A2-D8BC77375D97}" dt="2024-02-28T23:13:19.910" v="828" actId="478"/>
          <ac:spMkLst>
            <pc:docMk/>
            <pc:sldMk cId="1371429643" sldId="263"/>
            <ac:spMk id="43" creationId="{FA1E5116-BCE2-20DD-56DE-A6684BF1E114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4" creationId="{133CF75A-43C1-DF2B-D853-926FE7D0299D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5" creationId="{9B56C753-3D4C-9266-CD7F-B5EF29B70FA4}"/>
          </ac:spMkLst>
        </pc:spChg>
        <pc:spChg chg="add">
          <ac:chgData name="Elliott, Andrew" userId="57170054-896e-4a7b-99a2-5f2f342d2a77" providerId="ADAL" clId="{22A9A484-E00C-8D4C-A0A2-D8BC77375D97}" dt="2024-02-28T23:15:14.400" v="850"/>
          <ac:spMkLst>
            <pc:docMk/>
            <pc:sldMk cId="1371429643" sldId="263"/>
            <ac:spMk id="45" creationId="{D11738FC-6E16-A1DC-F56B-A0C22FC89A93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6" creationId="{1B453C16-812C-AC5C-4258-96CCA5C086CD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7" creationId="{3FB367C6-619F-6A58-94DD-3AB0A8CF1E62}"/>
          </ac:spMkLst>
        </pc:spChg>
        <pc:spChg chg="add">
          <ac:chgData name="Elliott, Andrew" userId="57170054-896e-4a7b-99a2-5f2f342d2a77" providerId="ADAL" clId="{22A9A484-E00C-8D4C-A0A2-D8BC77375D97}" dt="2024-02-28T23:15:50.983" v="854"/>
          <ac:spMkLst>
            <pc:docMk/>
            <pc:sldMk cId="1371429643" sldId="263"/>
            <ac:spMk id="47" creationId="{718B0693-E3BE-CA3A-C27B-83BE2CA10D7D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8" creationId="{C4C88DEC-1A77-934A-979E-F661000BC862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49" creationId="{C3F7D00C-E64B-A3E4-B87F-4C232AFDE80B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0" creationId="{6E2CED16-1951-B906-C3B6-710EE00CBE0E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1" creationId="{7B75DBFD-D9C5-A8A3-23D5-90141B97736B}"/>
          </ac:spMkLst>
        </pc:spChg>
        <pc:spChg chg="add del">
          <ac:chgData name="Elliott, Andrew" userId="57170054-896e-4a7b-99a2-5f2f342d2a77" providerId="ADAL" clId="{22A9A484-E00C-8D4C-A0A2-D8BC77375D97}" dt="2024-02-28T23:16:49.916" v="862" actId="22"/>
          <ac:spMkLst>
            <pc:docMk/>
            <pc:sldMk cId="1371429643" sldId="263"/>
            <ac:spMk id="51" creationId="{D197AE4F-00F6-8C4C-3D49-208826EF642A}"/>
          </ac:spMkLst>
        </pc:spChg>
        <pc:spChg chg="add">
          <ac:chgData name="Elliott, Andrew" userId="57170054-896e-4a7b-99a2-5f2f342d2a77" providerId="ADAL" clId="{22A9A484-E00C-8D4C-A0A2-D8BC77375D97}" dt="2024-02-28T23:17:04.217" v="863"/>
          <ac:spMkLst>
            <pc:docMk/>
            <pc:sldMk cId="1371429643" sldId="263"/>
            <ac:spMk id="52" creationId="{996F773A-4E68-F4B2-4212-F33F5440602D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2" creationId="{D84AA6C4-5118-CD9A-D199-2B9E5CB79EC0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3" creationId="{827F9F34-73EC-8A48-5A18-3FBFE216B38A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54" creationId="{D197C795-A8BA-2C1C-186F-99C01FF65BB4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4" creationId="{E5401D24-9454-5DD2-080B-6C3E06FCBFD2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5" creationId="{678EA817-6C02-7F93-BAC3-7036194D2D64}"/>
          </ac:spMkLst>
        </pc:spChg>
        <pc:spChg chg="add del">
          <ac:chgData name="Elliott, Andrew" userId="57170054-896e-4a7b-99a2-5f2f342d2a77" providerId="ADAL" clId="{22A9A484-E00C-8D4C-A0A2-D8BC77375D97}" dt="2024-02-28T23:18:39.895" v="879" actId="478"/>
          <ac:spMkLst>
            <pc:docMk/>
            <pc:sldMk cId="1371429643" sldId="263"/>
            <ac:spMk id="55" creationId="{D80DC9B6-9F12-E9CB-3C28-B9538B55F1B4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6" creationId="{84E6702E-055D-C1AE-8273-359EF25BF2C1}"/>
          </ac:spMkLst>
        </pc:spChg>
        <pc:spChg chg="add">
          <ac:chgData name="Elliott, Andrew" userId="57170054-896e-4a7b-99a2-5f2f342d2a77" providerId="ADAL" clId="{22A9A484-E00C-8D4C-A0A2-D8BC77375D97}" dt="2024-02-28T23:18:15.482" v="873"/>
          <ac:spMkLst>
            <pc:docMk/>
            <pc:sldMk cId="1371429643" sldId="263"/>
            <ac:spMk id="56" creationId="{BF4E57AE-011A-DED6-7555-D4BE9AEAF807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7" creationId="{06DED3EB-7568-4136-A757-FB2560169A86}"/>
          </ac:spMkLst>
        </pc:spChg>
        <pc:spChg chg="add">
          <ac:chgData name="Elliott, Andrew" userId="57170054-896e-4a7b-99a2-5f2f342d2a77" providerId="ADAL" clId="{22A9A484-E00C-8D4C-A0A2-D8BC77375D97}" dt="2024-02-28T23:18:21.115" v="874"/>
          <ac:spMkLst>
            <pc:docMk/>
            <pc:sldMk cId="1371429643" sldId="263"/>
            <ac:spMk id="57" creationId="{52B2EB13-A05D-BB68-A4AE-BE0ABBCEC419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8" creationId="{1D67299A-FC41-BEB8-6479-48821A71819B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59" creationId="{6176D851-E5EA-7C9E-63E0-6B41E7DBCEC2}"/>
          </ac:spMkLst>
        </pc:spChg>
        <pc:spChg chg="add">
          <ac:chgData name="Elliott, Andrew" userId="57170054-896e-4a7b-99a2-5f2f342d2a77" providerId="ADAL" clId="{22A9A484-E00C-8D4C-A0A2-D8BC77375D97}" dt="2024-02-28T23:18:40.682" v="880"/>
          <ac:spMkLst>
            <pc:docMk/>
            <pc:sldMk cId="1371429643" sldId="263"/>
            <ac:spMk id="59" creationId="{FAD6CA57-84A8-79A5-8278-E86D0D49F356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60" creationId="{EA0764BB-C251-238F-79B1-B0C7A6E7BCBC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61" creationId="{03FCF598-5CAE-2A40-060E-A8F1B85B353A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1" creationId="{BAE900DE-C6A9-9A74-C358-0CB13930589E}"/>
          </ac:spMkLst>
        </pc:spChg>
        <pc:spChg chg="add">
          <ac:chgData name="Elliott, Andrew" userId="57170054-896e-4a7b-99a2-5f2f342d2a77" providerId="ADAL" clId="{22A9A484-E00C-8D4C-A0A2-D8BC77375D97}" dt="2024-02-29T01:59:22.068" v="902"/>
          <ac:spMkLst>
            <pc:docMk/>
            <pc:sldMk cId="1371429643" sldId="263"/>
            <ac:spMk id="62" creationId="{61C8C0B4-5914-7A7D-DB27-06A416573863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2" creationId="{8ED4C06C-35F5-0911-9D8F-7574757F2114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3" creationId="{CABB1669-625B-C275-C682-A2CDEC6577B9}"/>
          </ac:spMkLst>
        </pc:spChg>
        <pc:spChg chg="add">
          <ac:chgData name="Elliott, Andrew" userId="57170054-896e-4a7b-99a2-5f2f342d2a77" providerId="ADAL" clId="{22A9A484-E00C-8D4C-A0A2-D8BC77375D97}" dt="2024-02-29T02:00:18.094" v="906"/>
          <ac:spMkLst>
            <pc:docMk/>
            <pc:sldMk cId="1371429643" sldId="263"/>
            <ac:spMk id="64" creationId="{6A8CD9A0-808B-6146-F819-322614FCF224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4" creationId="{BA085291-569A-46C2-34CD-D3E6FDF031C9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5" creationId="{0A33DD0D-C57E-0566-8EE5-0A0ACEFA63C5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6" creationId="{030706D7-839A-E74A-AD89-A56C72837F8A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66" creationId="{B593DE47-336B-886C-C130-B89D4CC43DB2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7" creationId="{100468F8-E2C8-C115-F9EC-322CE1F8B156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8" creationId="{4E767897-A6AF-0B68-5D70-E013724B1603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68" creationId="{616C7EE1-BF82-79B0-65ED-A5CDC4076CB2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69" creationId="{ED623B5B-9D4C-7531-88CE-C323EA2226DC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70" creationId="{04FF1CC8-FB3A-7789-89CE-A5238AF78142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70" creationId="{BD44DA18-C7BE-3578-24A3-F6722AE4FA52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71" creationId="{48112AAD-19B6-FA4D-8F5D-F77AEC0A5727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72" creationId="{017BCD80-FC78-7684-9DF3-855FED46968D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73" creationId="{89A7D06A-0B66-66B2-1EAA-74C416564951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73" creationId="{9F14328B-EE61-B673-26B8-93C440613855}"/>
          </ac:spMkLst>
        </pc:spChg>
        <pc:spChg chg="add mod">
          <ac:chgData name="Elliott, Andrew" userId="57170054-896e-4a7b-99a2-5f2f342d2a77" providerId="ADAL" clId="{22A9A484-E00C-8D4C-A0A2-D8BC77375D97}" dt="2024-03-04T06:34:56.066" v="2089" actId="1076"/>
          <ac:spMkLst>
            <pc:docMk/>
            <pc:sldMk cId="1371429643" sldId="263"/>
            <ac:spMk id="74" creationId="{490EC4CD-D4B2-9209-A6B7-B8B1F4546347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5" creationId="{D397CD3E-7637-556C-AEF4-113965E03A0D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6" creationId="{D9186A01-4616-62FB-5B99-8C0BC94677CE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7" creationId="{B76204DC-E02D-93BE-6C0B-6B5F6474E5F6}"/>
          </ac:spMkLst>
        </pc:spChg>
        <pc:spChg chg="add del mod">
          <ac:chgData name="Elliott, Andrew" userId="57170054-896e-4a7b-99a2-5f2f342d2a77" providerId="ADAL" clId="{22A9A484-E00C-8D4C-A0A2-D8BC77375D97}" dt="2024-02-29T05:35:17.966" v="1147" actId="21"/>
          <ac:spMkLst>
            <pc:docMk/>
            <pc:sldMk cId="1371429643" sldId="263"/>
            <ac:spMk id="78" creationId="{78234B02-81DD-2BC6-689A-21B7033248FC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8" creationId="{AEE8B25B-A37E-E510-EF65-EA0391AEA797}"/>
          </ac:spMkLst>
        </pc:spChg>
        <pc:spChg chg="add del mod">
          <ac:chgData name="Elliott, Andrew" userId="57170054-896e-4a7b-99a2-5f2f342d2a77" providerId="ADAL" clId="{22A9A484-E00C-8D4C-A0A2-D8BC77375D97}" dt="2024-02-29T05:35:17.966" v="1147" actId="21"/>
          <ac:spMkLst>
            <pc:docMk/>
            <pc:sldMk cId="1371429643" sldId="263"/>
            <ac:spMk id="79" creationId="{DF494CA5-D21E-8A6F-512F-AA0C8DCDC113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79" creationId="{E439A8B2-2AA8-486D-6AA3-09021C0A781B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80" creationId="{20E17391-C944-C006-C11D-153F54A33EA5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82" creationId="{5DCF62A6-5B3C-08BC-4CA1-A2775B7E9325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84" creationId="{D4361DE1-B027-6C95-8FCA-637CDB38FF72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86" creationId="{640BBCFE-95C6-C1F8-C4C3-73C23521CD7F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88" creationId="{473047D4-1F3E-FF76-9477-1194134C2C5C}"/>
          </ac:spMkLst>
        </pc:spChg>
        <pc:spChg chg="mod">
          <ac:chgData name="Elliott, Andrew" userId="57170054-896e-4a7b-99a2-5f2f342d2a77" providerId="ADAL" clId="{22A9A484-E00C-8D4C-A0A2-D8BC77375D97}" dt="2024-03-04T06:39:59.641" v="2207" actId="1036"/>
          <ac:spMkLst>
            <pc:docMk/>
            <pc:sldMk cId="1371429643" sldId="263"/>
            <ac:spMk id="90" creationId="{3C2C63B4-AA11-4260-8482-48C78968D8B0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91" creationId="{11A83999-CFFB-5BA2-1DC2-2BCC6FBEDA54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93" creationId="{5B549AC5-00A6-FE9A-AB02-CB83CDE0EF07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94" creationId="{8676D2D9-D885-3601-4716-5BF038744E86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95" creationId="{6ABD1A77-FD35-6D92-0CC6-99389572DCE8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96" creationId="{8A7E31A7-2FEA-F283-4F04-8A05E9B1C5C3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97" creationId="{77391BB9-2805-7C3C-5624-B5006A4A2E2E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97" creationId="{BE157D5A-8FEF-7D4A-29B6-92D3F67EB788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98" creationId="{5AF3E0B7-D066-37BD-3C4B-5ED2CB0ECCBA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98" creationId="{C745E38B-6CB2-8A5B-B9AA-465C9D677BC2}"/>
          </ac:spMkLst>
        </pc:spChg>
        <pc:spChg chg="add del mod">
          <ac:chgData name="Elliott, Andrew" userId="57170054-896e-4a7b-99a2-5f2f342d2a77" providerId="ADAL" clId="{22A9A484-E00C-8D4C-A0A2-D8BC77375D97}" dt="2024-02-29T06:53:37.805" v="1689" actId="478"/>
          <ac:spMkLst>
            <pc:docMk/>
            <pc:sldMk cId="1371429643" sldId="263"/>
            <ac:spMk id="99" creationId="{1493EFD3-F244-2663-2DA0-7D0FCFD05B7C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99" creationId="{5176112C-A2AD-FA62-32F7-F684E5337E8F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0" creationId="{CAE07292-5CDD-7905-EEAF-BC19035E5FAF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1" creationId="{99B0EEA7-D15D-1FA3-C600-EE05E0A29552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2" creationId="{A9CB88D1-E7D1-09BD-4AC1-09B181C49596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3" creationId="{54F41EED-E0B5-5ED4-7481-1CC78E15CF32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4" creationId="{F2D15F18-A4A4-D84D-FC80-5C9F8E8C1AA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5" creationId="{16C300BB-8636-5310-EF1F-9C4F6FCA46AB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7" creationId="{1DBBEE10-2F11-F97F-A779-D60051EDEA1D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08" creationId="{DC751714-56B3-5EEC-95DC-1C2B58B925DF}"/>
          </ac:spMkLst>
        </pc:spChg>
        <pc:spChg chg="add del mod">
          <ac:chgData name="Elliott, Andrew" userId="57170054-896e-4a7b-99a2-5f2f342d2a77" providerId="ADAL" clId="{22A9A484-E00C-8D4C-A0A2-D8BC77375D97}" dt="2024-02-29T06:29:43.962" v="1349" actId="21"/>
          <ac:spMkLst>
            <pc:docMk/>
            <pc:sldMk cId="1371429643" sldId="263"/>
            <ac:spMk id="109" creationId="{BAA632F1-D1C3-5413-351E-DA0D283F1501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09" creationId="{D0E47B76-CF57-35A5-363A-0CAE69552716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0" creationId="{9A198F01-748F-1093-8C91-EE8F12A0C3AA}"/>
          </ac:spMkLst>
        </pc:spChg>
        <pc:spChg chg="add del mod">
          <ac:chgData name="Elliott, Andrew" userId="57170054-896e-4a7b-99a2-5f2f342d2a77" providerId="ADAL" clId="{22A9A484-E00C-8D4C-A0A2-D8BC77375D97}" dt="2024-02-29T06:29:43.962" v="1349" actId="21"/>
          <ac:spMkLst>
            <pc:docMk/>
            <pc:sldMk cId="1371429643" sldId="263"/>
            <ac:spMk id="111" creationId="{C0B36DB0-98D1-CEB3-34E9-D01C817C409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1" creationId="{CD41F488-32A4-6AF2-1CA6-D8816AA3241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2" creationId="{74F1A59F-F01B-ECAE-5425-911BE9961E8D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4" creationId="{9F4150A2-5CEA-AAA2-8499-FDDE0BD5A025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16" creationId="{F58724C8-9ECE-B6D4-7B1E-0A17B8CA71BC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17" creationId="{E04774DA-14DD-1DCC-6001-6AAFED0BF587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8" creationId="{A8A16AB9-2C62-B866-5241-7E8A42CA20D1}"/>
          </ac:spMkLst>
        </pc:spChg>
        <pc:spChg chg="add del mod">
          <ac:chgData name="Elliott, Andrew" userId="57170054-896e-4a7b-99a2-5f2f342d2a77" providerId="ADAL" clId="{22A9A484-E00C-8D4C-A0A2-D8BC77375D97}" dt="2024-02-29T06:53:26.497" v="1688" actId="478"/>
          <ac:spMkLst>
            <pc:docMk/>
            <pc:sldMk cId="1371429643" sldId="263"/>
            <ac:spMk id="119" creationId="{7D06270F-4698-B872-142E-CC8AC55739D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19" creationId="{BB47B7ED-902A-F8D4-7B0E-EF1AE82C048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20" creationId="{4356962B-5552-65B3-4537-0B493ABA9C7F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21" creationId="{4EEE3A15-1010-0245-C4B3-33C689498361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22" creationId="{A21ECD7C-8279-35C7-FA45-EBEC187CAF82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123" creationId="{94E9ED65-3921-3F1E-00ED-83573A537DE0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124" creationId="{DB18834A-3540-6C5D-2632-42888AE38328}"/>
          </ac:spMkLst>
        </pc:spChg>
        <pc:spChg chg="add mod">
          <ac:chgData name="Elliott, Andrew" userId="57170054-896e-4a7b-99a2-5f2f342d2a77" providerId="ADAL" clId="{22A9A484-E00C-8D4C-A0A2-D8BC77375D97}" dt="2024-03-04T07:06:23.839" v="2796" actId="164"/>
          <ac:spMkLst>
            <pc:docMk/>
            <pc:sldMk cId="1371429643" sldId="263"/>
            <ac:spMk id="125" creationId="{1CB516F8-4FF4-19A0-CA0D-E42315AF54DD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26" creationId="{A3E37551-CAB2-DA11-C7AF-31245247219D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27" creationId="{5667DEB5-3F84-552D-99F6-CDC0CC50DD94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28" creationId="{AD1BAF0D-A980-FFA7-1FB8-3324BF68C6C7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29" creationId="{FE282C90-BDC3-E60F-736A-92BFAADDAF11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0" creationId="{3588C98B-1525-C62A-CE6C-88970E5C010A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1" creationId="{8E513C5B-A391-E1D1-4C0C-1D0B4AC50E7A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2" creationId="{2D733D3F-004C-04DA-E3A6-E07BABDB2B36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3" creationId="{01F350DA-00C3-E354-2CFF-D24DD49AAC25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4" creationId="{73DCFDC4-02AF-844E-361E-BC8A87CFDDCC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5" creationId="{CC48164B-FE2E-3A19-DF9D-823276536872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6" creationId="{28C1E5A5-600B-A3BA-05E8-BFF3F2EDFA6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7" creationId="{F15E3844-0B4A-FE86-09CF-7F9B318526FE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8" creationId="{B92CBDF8-AAEA-6F7B-5E80-269D2EBB69AA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39" creationId="{574F9FC3-71ED-98C2-973E-5FFBEA6103AE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0" creationId="{29CBFB06-7559-4B08-38F6-6B3702C4E83D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1" creationId="{705BEF58-443D-D986-8711-4B4BCC0E4CB7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2" creationId="{E929DF65-8E35-A451-D8E9-F9D28ED7FB33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3" creationId="{0B56CA28-7B8C-8F54-8766-A41607F59571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4" creationId="{0E84251C-C6D6-1698-65D5-221FB286F06B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5" creationId="{757C9969-D06F-ABD1-F9D9-08A74B6FA191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6" creationId="{6A47C3BD-B4D3-1CE2-FDB5-4BB6E1E7470B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7" creationId="{A3C68A0C-AD3C-9E38-B3F7-10C682394B8B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8" creationId="{10CF5F00-AB2B-92CD-0FB6-0EDDB5AF3FC0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49" creationId="{E3F44F05-F779-2227-BB70-F941E6773581}"/>
          </ac:spMkLst>
        </pc:spChg>
        <pc:spChg chg="add mod">
          <ac:chgData name="Elliott, Andrew" userId="57170054-896e-4a7b-99a2-5f2f342d2a77" providerId="ADAL" clId="{22A9A484-E00C-8D4C-A0A2-D8BC77375D97}" dt="2024-03-04T07:06:08.515" v="2795" actId="164"/>
          <ac:spMkLst>
            <pc:docMk/>
            <pc:sldMk cId="1371429643" sldId="263"/>
            <ac:spMk id="150" creationId="{EB15A53F-9F86-BE23-718D-8C98E862B0E0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1" creationId="{D0678F3F-A6F8-8B1A-7F95-706698972292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2" creationId="{E1AB4919-BD15-6A3A-B38B-645182824EA1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3" creationId="{782E6055-83EF-0C5B-6625-09C975B5044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4" creationId="{ED1427C8-F19A-401A-502C-9C2BC1A65BFE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5" creationId="{3CC57382-ED28-077F-1628-57664BDEA9D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6" creationId="{28B2E3F8-8721-6317-3E1C-E868FDB97F2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7" creationId="{7B7CBC5D-965F-FEB3-8F0A-19B8E982C685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8" creationId="{72A6CFD0-361D-4493-49F8-91C590A84F29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59" creationId="{F350C311-4BBB-95CC-E1A6-6EE08C522044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0" creationId="{4D520A10-A15D-A634-9909-0356B0BA4B8A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1" creationId="{8235FCE3-32AB-2990-27E7-8B0C2993E97D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2" creationId="{B0C84C1A-3A9D-C10D-8E85-6741081A639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3" creationId="{FC7CA97B-FF50-2469-AB72-C0D866BAACAD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4" creationId="{8BF67B17-A030-7461-B258-32EBF98E944D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5" creationId="{3D800EC1-7E3B-3317-0E79-D4774B6353F0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6" creationId="{A28D739A-9E57-8222-0380-2538BC0EA2EC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7" creationId="{7CEF484C-F237-DD1F-3EC8-3ADAEC75A6EE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8" creationId="{580E601F-70A9-BF8C-A1BD-5D16EDB0F0FC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69" creationId="{20E2AD61-C614-9EF6-F676-E3EE2156CDA8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0" creationId="{80EBC32A-0B0C-298A-03B8-3EDB9CB97E59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1" creationId="{06082637-7211-4EA3-B33E-57F8199440FA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2" creationId="{FD390A58-2B32-2480-1F0B-848FE9CFD13F}"/>
          </ac:spMkLst>
        </pc:spChg>
        <pc:spChg chg="add del mod">
          <ac:chgData name="Elliott, Andrew" userId="57170054-896e-4a7b-99a2-5f2f342d2a77" providerId="ADAL" clId="{22A9A484-E00C-8D4C-A0A2-D8BC77375D97}" dt="2024-03-04T06:55:40.466" v="2633" actId="478"/>
          <ac:spMkLst>
            <pc:docMk/>
            <pc:sldMk cId="1371429643" sldId="263"/>
            <ac:spMk id="173" creationId="{547ED444-CA46-EAFC-CDF1-B2C89298CE4D}"/>
          </ac:spMkLst>
        </pc:spChg>
        <pc:spChg chg="add del mod">
          <ac:chgData name="Elliott, Andrew" userId="57170054-896e-4a7b-99a2-5f2f342d2a77" providerId="ADAL" clId="{22A9A484-E00C-8D4C-A0A2-D8BC77375D97}" dt="2024-03-04T06:55:40.466" v="2633" actId="478"/>
          <ac:spMkLst>
            <pc:docMk/>
            <pc:sldMk cId="1371429643" sldId="263"/>
            <ac:spMk id="174" creationId="{5CA37DC0-5D60-3C9C-4B41-BD5FB720A349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5" creationId="{5C3A6A67-27F0-FEE2-BC5D-05FB8923580C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6" creationId="{93E43D1D-1B0B-44C3-89D7-A9F8D064FE8A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7" creationId="{E269DF48-724C-2360-4864-D35B08AF23ED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78" creationId="{918BB0EC-31E3-3B45-10C1-1397E302BD29}"/>
          </ac:spMkLst>
        </pc:spChg>
        <pc:spChg chg="add del mod">
          <ac:chgData name="Elliott, Andrew" userId="57170054-896e-4a7b-99a2-5f2f342d2a77" providerId="ADAL" clId="{22A9A484-E00C-8D4C-A0A2-D8BC77375D97}" dt="2024-03-04T06:55:48.236" v="2647" actId="478"/>
          <ac:spMkLst>
            <pc:docMk/>
            <pc:sldMk cId="1371429643" sldId="263"/>
            <ac:spMk id="179" creationId="{44C5AE54-438A-7D56-3405-59BEC65AA7D7}"/>
          </ac:spMkLst>
        </pc:spChg>
        <pc:spChg chg="del">
          <ac:chgData name="Elliott, Andrew" userId="57170054-896e-4a7b-99a2-5f2f342d2a77" providerId="ADAL" clId="{22A9A484-E00C-8D4C-A0A2-D8BC77375D97}" dt="2024-02-29T01:56:01.878" v="899" actId="478"/>
          <ac:spMkLst>
            <pc:docMk/>
            <pc:sldMk cId="1371429643" sldId="263"/>
            <ac:spMk id="179" creationId="{6F6074BC-209B-230E-26E6-70F4E26354B5}"/>
          </ac:spMkLst>
        </pc:spChg>
        <pc:spChg chg="del">
          <ac:chgData name="Elliott, Andrew" userId="57170054-896e-4a7b-99a2-5f2f342d2a77" providerId="ADAL" clId="{22A9A484-E00C-8D4C-A0A2-D8BC77375D97}" dt="2024-02-29T01:56:01.878" v="899" actId="478"/>
          <ac:spMkLst>
            <pc:docMk/>
            <pc:sldMk cId="1371429643" sldId="263"/>
            <ac:spMk id="180" creationId="{A479E3BD-6684-DD99-99A3-BD4774D1DCCE}"/>
          </ac:spMkLst>
        </pc:spChg>
        <pc:spChg chg="add del mod">
          <ac:chgData name="Elliott, Andrew" userId="57170054-896e-4a7b-99a2-5f2f342d2a77" providerId="ADAL" clId="{22A9A484-E00C-8D4C-A0A2-D8BC77375D97}" dt="2024-03-04T06:55:48.236" v="2647" actId="478"/>
          <ac:spMkLst>
            <pc:docMk/>
            <pc:sldMk cId="1371429643" sldId="263"/>
            <ac:spMk id="180" creationId="{C0D692FE-D640-EF94-BB8D-C288EB5EFB13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1" creationId="{47C4B562-CE89-1C7B-3B6B-570675EEE63E}"/>
          </ac:spMkLst>
        </pc:spChg>
        <pc:spChg chg="del mod">
          <ac:chgData name="Elliott, Andrew" userId="57170054-896e-4a7b-99a2-5f2f342d2a77" providerId="ADAL" clId="{22A9A484-E00C-8D4C-A0A2-D8BC77375D97}" dt="2024-02-29T05:35:17.966" v="1147" actId="21"/>
          <ac:spMkLst>
            <pc:docMk/>
            <pc:sldMk cId="1371429643" sldId="263"/>
            <ac:spMk id="181" creationId="{D8DB803A-4BFE-3309-F7A0-9B9777C317B2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2" creationId="{31DFFCDA-635F-D3D1-5A92-8BA94A75B80E}"/>
          </ac:spMkLst>
        </pc:spChg>
        <pc:spChg chg="del mod">
          <ac:chgData name="Elliott, Andrew" userId="57170054-896e-4a7b-99a2-5f2f342d2a77" providerId="ADAL" clId="{22A9A484-E00C-8D4C-A0A2-D8BC77375D97}" dt="2024-02-29T06:20:47.372" v="1259" actId="21"/>
          <ac:spMkLst>
            <pc:docMk/>
            <pc:sldMk cId="1371429643" sldId="263"/>
            <ac:spMk id="182" creationId="{F9FED5E7-D559-2854-5840-3B18BD1B84A2}"/>
          </ac:spMkLst>
        </pc:spChg>
        <pc:spChg chg="del mod">
          <ac:chgData name="Elliott, Andrew" userId="57170054-896e-4a7b-99a2-5f2f342d2a77" providerId="ADAL" clId="{22A9A484-E00C-8D4C-A0A2-D8BC77375D97}" dt="2024-02-29T06:20:47.372" v="1259" actId="21"/>
          <ac:spMkLst>
            <pc:docMk/>
            <pc:sldMk cId="1371429643" sldId="263"/>
            <ac:spMk id="183" creationId="{482EF2E1-39F2-4DCC-A9DE-75FC018A467E}"/>
          </ac:spMkLst>
        </pc:spChg>
        <pc:spChg chg="add del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3" creationId="{A17953F2-3E07-CB02-A9D6-C8BB28ACAF76}"/>
          </ac:spMkLst>
        </pc:spChg>
        <pc:spChg chg="del mod">
          <ac:chgData name="Elliott, Andrew" userId="57170054-896e-4a7b-99a2-5f2f342d2a77" providerId="ADAL" clId="{22A9A484-E00C-8D4C-A0A2-D8BC77375D97}" dt="2024-02-29T06:20:47.372" v="1259" actId="21"/>
          <ac:spMkLst>
            <pc:docMk/>
            <pc:sldMk cId="1371429643" sldId="263"/>
            <ac:spMk id="184" creationId="{0183E78C-5288-FAF8-917B-C3F5B834471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4" creationId="{5A53F5D6-BCE9-99C6-99FA-58495DE3A479}"/>
          </ac:spMkLst>
        </pc:spChg>
        <pc:spChg chg="add del mod">
          <ac:chgData name="Elliott, Andrew" userId="57170054-896e-4a7b-99a2-5f2f342d2a77" providerId="ADAL" clId="{22A9A484-E00C-8D4C-A0A2-D8BC77375D97}" dt="2024-03-04T06:55:50.832" v="2648" actId="478"/>
          <ac:spMkLst>
            <pc:docMk/>
            <pc:sldMk cId="1371429643" sldId="263"/>
            <ac:spMk id="185" creationId="{745FB0CE-CE7C-FF57-A381-E265F3502D7C}"/>
          </ac:spMkLst>
        </pc:spChg>
        <pc:spChg chg="add del mod">
          <ac:chgData name="Elliott, Andrew" userId="57170054-896e-4a7b-99a2-5f2f342d2a77" providerId="ADAL" clId="{22A9A484-E00C-8D4C-A0A2-D8BC77375D97}" dt="2024-03-04T06:55:50.832" v="2648" actId="478"/>
          <ac:spMkLst>
            <pc:docMk/>
            <pc:sldMk cId="1371429643" sldId="263"/>
            <ac:spMk id="186" creationId="{1D48D611-9502-B209-C892-FF87BBA85605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7" creationId="{8B77DFAA-6129-FFA3-470A-5FA46ACE7C7F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8" creationId="{19EFB4C0-3B57-9F37-275E-A57835BC9733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89" creationId="{C1958B25-20B5-7074-29A1-DEA914BD9FF5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0" creationId="{ECB8816C-5739-5546-855D-6B3EFF88BA5C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1" creationId="{07545D42-8475-9F72-E780-9D4AD7C237A4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2" creationId="{6A41CCD1-8E30-A4BD-9006-1642CDF48EA0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3" creationId="{2551A86D-6AC9-DF8E-62A5-DF804B36EFBB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4" creationId="{41BF3C85-0CF0-0B2C-1044-534673C4B71F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5" creationId="{7FEA3BD3-0845-29CB-0663-9CDE18B0C774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6" creationId="{471D765C-705A-B3F3-57E4-47D2A26303A5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7" creationId="{B52B9541-D712-5BE2-1B6A-771CC49F605B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8" creationId="{C424D144-68ED-E0C5-918D-CB6B8E3E342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199" creationId="{F5B14ED0-738D-029A-E4E0-107C12B4EC3E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0" creationId="{9B0C0059-CDCD-C0BA-E77F-4E655C1A51B1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1" creationId="{B9A6A486-7057-C91B-6D66-B9134E793ABF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2" creationId="{0C83A92E-CA03-526E-1CB4-EEC41D2B353E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3" creationId="{9C4C735F-DE2A-A06A-0CA3-D8D0BD590C93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4" creationId="{A5F3B421-DD7F-55B5-B7F4-FB9489318527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5" creationId="{1A2BEDD0-66BD-B4D3-9CB5-0673D7004553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6" creationId="{BB7F5645-EDC8-1A67-E398-115562741A89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7" creationId="{78BCF484-0F4E-7DE0-AE70-21D1D4076B28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8" creationId="{F9E9E941-4B03-95C3-5EC6-9D8A4E04D854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09" creationId="{92D9C2FB-DD43-3880-BF6F-BA4C2A6BED73}"/>
          </ac:spMkLst>
        </pc:spChg>
        <pc:spChg chg="add mod">
          <ac:chgData name="Elliott, Andrew" userId="57170054-896e-4a7b-99a2-5f2f342d2a77" providerId="ADAL" clId="{22A9A484-E00C-8D4C-A0A2-D8BC77375D97}" dt="2024-03-04T07:05:57.155" v="2794" actId="164"/>
          <ac:spMkLst>
            <pc:docMk/>
            <pc:sldMk cId="1371429643" sldId="263"/>
            <ac:spMk id="210" creationId="{566D9637-B302-76F5-7FFF-AB1945FED478}"/>
          </ac:spMkLst>
        </pc:spChg>
        <pc:grpChg chg="add del mod">
          <ac:chgData name="Elliott, Andrew" userId="57170054-896e-4a7b-99a2-5f2f342d2a77" providerId="ADAL" clId="{22A9A484-E00C-8D4C-A0A2-D8BC77375D97}" dt="2024-02-28T22:56:43.634" v="539" actId="165"/>
          <ac:grpSpMkLst>
            <pc:docMk/>
            <pc:sldMk cId="1371429643" sldId="263"/>
            <ac:grpSpMk id="3" creationId="{CDA1215B-496F-3F78-8162-136D4FA24BA2}"/>
          </ac:grpSpMkLst>
        </pc:grpChg>
        <pc:grpChg chg="del">
          <ac:chgData name="Elliott, Andrew" userId="57170054-896e-4a7b-99a2-5f2f342d2a77" providerId="ADAL" clId="{22A9A484-E00C-8D4C-A0A2-D8BC77375D97}" dt="2024-02-28T22:56:38.304" v="537" actId="21"/>
          <ac:grpSpMkLst>
            <pc:docMk/>
            <pc:sldMk cId="1371429643" sldId="263"/>
            <ac:grpSpMk id="185" creationId="{A512573C-AF1F-CE52-FC33-DAD6495328E1}"/>
          </ac:grpSpMkLst>
        </pc:grpChg>
        <pc:grpChg chg="add del mod">
          <ac:chgData name="Elliott, Andrew" userId="57170054-896e-4a7b-99a2-5f2f342d2a77" providerId="ADAL" clId="{22A9A484-E00C-8D4C-A0A2-D8BC77375D97}" dt="2024-03-04T07:06:35.597" v="2802" actId="478"/>
          <ac:grpSpMkLst>
            <pc:docMk/>
            <pc:sldMk cId="1371429643" sldId="263"/>
            <ac:grpSpMk id="211" creationId="{E2630E23-08F2-6005-CA9F-1978253F868E}"/>
          </ac:grpSpMkLst>
        </pc:grpChg>
        <pc:grpChg chg="add del mod">
          <ac:chgData name="Elliott, Andrew" userId="57170054-896e-4a7b-99a2-5f2f342d2a77" providerId="ADAL" clId="{22A9A484-E00C-8D4C-A0A2-D8BC77375D97}" dt="2024-03-04T07:06:27.302" v="2798" actId="478"/>
          <ac:grpSpMkLst>
            <pc:docMk/>
            <pc:sldMk cId="1371429643" sldId="263"/>
            <ac:grpSpMk id="212" creationId="{25A959A1-7BDA-CB6D-3372-C1336604A283}"/>
          </ac:grpSpMkLst>
        </pc:grpChg>
        <pc:grpChg chg="add del mod">
          <ac:chgData name="Elliott, Andrew" userId="57170054-896e-4a7b-99a2-5f2f342d2a77" providerId="ADAL" clId="{22A9A484-E00C-8D4C-A0A2-D8BC77375D97}" dt="2024-03-04T07:06:28.943" v="2800" actId="478"/>
          <ac:grpSpMkLst>
            <pc:docMk/>
            <pc:sldMk cId="1371429643" sldId="263"/>
            <ac:grpSpMk id="213" creationId="{EDA8C340-2EB2-3C87-24B8-4D68F0AFD9CD}"/>
          </ac:grpSpMkLst>
        </pc:grpChg>
        <pc:graphicFrameChg chg="add del mod">
          <ac:chgData name="Elliott, Andrew" userId="57170054-896e-4a7b-99a2-5f2f342d2a77" providerId="ADAL" clId="{22A9A484-E00C-8D4C-A0A2-D8BC77375D97}" dt="2024-03-04T06:20:37.444" v="1759" actId="1035"/>
          <ac:graphicFrameMkLst>
            <pc:docMk/>
            <pc:sldMk cId="1371429643" sldId="263"/>
            <ac:graphicFrameMk id="2" creationId="{405AEA0A-9C3A-ED8B-F0C5-06BFDB0F0E58}"/>
          </ac:graphicFrameMkLst>
        </pc:graphicFrameChg>
        <pc:graphicFrameChg chg="mod modGraphic">
          <ac:chgData name="Elliott, Andrew" userId="57170054-896e-4a7b-99a2-5f2f342d2a77" providerId="ADAL" clId="{22A9A484-E00C-8D4C-A0A2-D8BC77375D97}" dt="2024-03-04T06:20:37.444" v="1759" actId="1035"/>
          <ac:graphicFrameMkLst>
            <pc:docMk/>
            <pc:sldMk cId="1371429643" sldId="263"/>
            <ac:graphicFrameMk id="27" creationId="{E7E724FC-9F35-4062-644C-B833C066934A}"/>
          </ac:graphicFrameMkLst>
        </pc:graphicFrameChg>
        <pc:graphicFrameChg chg="del">
          <ac:chgData name="Elliott, Andrew" userId="57170054-896e-4a7b-99a2-5f2f342d2a77" providerId="ADAL" clId="{22A9A484-E00C-8D4C-A0A2-D8BC77375D97}" dt="2024-02-28T22:56:24.262" v="536" actId="478"/>
          <ac:graphicFrameMkLst>
            <pc:docMk/>
            <pc:sldMk cId="1371429643" sldId="263"/>
            <ac:graphicFrameMk id="33" creationId="{726FD361-C0CE-8FDF-8AA1-2DF96D636DA2}"/>
          </ac:graphicFrameMkLst>
        </pc:graphicFrameChg>
        <pc:picChg chg="add del mod">
          <ac:chgData name="Elliott, Andrew" userId="57170054-896e-4a7b-99a2-5f2f342d2a77" providerId="ADAL" clId="{22A9A484-E00C-8D4C-A0A2-D8BC77375D97}" dt="2024-02-28T23:15:17.400" v="852" actId="478"/>
          <ac:picMkLst>
            <pc:docMk/>
            <pc:sldMk cId="1371429643" sldId="263"/>
            <ac:picMk id="41" creationId="{20E360CE-BF42-CD48-9122-ABE42C74B2DD}"/>
          </ac:picMkLst>
        </pc:picChg>
        <pc:picChg chg="add del mod">
          <ac:chgData name="Elliott, Andrew" userId="57170054-896e-4a7b-99a2-5f2f342d2a77" providerId="ADAL" clId="{22A9A484-E00C-8D4C-A0A2-D8BC77375D97}" dt="2024-02-29T02:29:34.548" v="1035" actId="478"/>
          <ac:picMkLst>
            <pc:docMk/>
            <pc:sldMk cId="1371429643" sldId="263"/>
            <ac:picMk id="46" creationId="{50D34B3B-C8C9-F530-A57F-1860E8F2FC8B}"/>
          </ac:picMkLst>
        </pc:picChg>
        <pc:picChg chg="add del mod">
          <ac:chgData name="Elliott, Andrew" userId="57170054-896e-4a7b-99a2-5f2f342d2a77" providerId="ADAL" clId="{22A9A484-E00C-8D4C-A0A2-D8BC77375D97}" dt="2024-02-29T02:29:34.548" v="1035" actId="478"/>
          <ac:picMkLst>
            <pc:docMk/>
            <pc:sldMk cId="1371429643" sldId="263"/>
            <ac:picMk id="48" creationId="{F9C22C7D-7FB6-438C-95CA-4C7FC6B15802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53" creationId="{AF60A7BE-6297-4DA7-D856-F89654004563}"/>
          </ac:picMkLst>
        </pc:picChg>
        <pc:picChg chg="add mod">
          <ac:chgData name="Elliott, Andrew" userId="57170054-896e-4a7b-99a2-5f2f342d2a77" providerId="ADAL" clId="{22A9A484-E00C-8D4C-A0A2-D8BC77375D97}" dt="2024-02-28T23:18:27.474" v="877" actId="1076"/>
          <ac:picMkLst>
            <pc:docMk/>
            <pc:sldMk cId="1371429643" sldId="263"/>
            <ac:picMk id="58" creationId="{48FE8C8A-AB22-3F98-6ADB-88645351FC3C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60" creationId="{2C396189-E710-B6A6-0EB4-57CA0741CE8C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63" creationId="{07C7C74E-CDB0-E869-EA92-208159B8451C}"/>
          </ac:picMkLst>
        </pc:picChg>
        <pc:picChg chg="add del mod">
          <ac:chgData name="Elliott, Andrew" userId="57170054-896e-4a7b-99a2-5f2f342d2a77" providerId="ADAL" clId="{22A9A484-E00C-8D4C-A0A2-D8BC77375D97}" dt="2024-02-29T02:29:34.548" v="1035" actId="478"/>
          <ac:picMkLst>
            <pc:docMk/>
            <pc:sldMk cId="1371429643" sldId="263"/>
            <ac:picMk id="65" creationId="{83FE128E-FE70-562E-9E9C-798B13829704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71" creationId="{C384A7D7-048C-FEB8-F350-4A4F0DC629E1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72" creationId="{0B4C0E6E-6954-6003-6FB9-64FA5ED59207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74" creationId="{832876B8-F747-09FD-0667-18E2ED33A987}"/>
          </ac:picMkLst>
        </pc:picChg>
        <pc:picChg chg="add mod">
          <ac:chgData name="Elliott, Andrew" userId="57170054-896e-4a7b-99a2-5f2f342d2a77" providerId="ADAL" clId="{22A9A484-E00C-8D4C-A0A2-D8BC77375D97}" dt="2024-03-04T07:06:23.839" v="2796" actId="164"/>
          <ac:picMkLst>
            <pc:docMk/>
            <pc:sldMk cId="1371429643" sldId="263"/>
            <ac:picMk id="81" creationId="{90D530A5-12A8-349D-FA3D-39733D80D5FA}"/>
          </ac:picMkLst>
        </pc:picChg>
        <pc:picChg chg="add mod">
          <ac:chgData name="Elliott, Andrew" userId="57170054-896e-4a7b-99a2-5f2f342d2a77" providerId="ADAL" clId="{22A9A484-E00C-8D4C-A0A2-D8BC77375D97}" dt="2024-03-04T07:06:23.839" v="2796" actId="164"/>
          <ac:picMkLst>
            <pc:docMk/>
            <pc:sldMk cId="1371429643" sldId="263"/>
            <ac:picMk id="83" creationId="{33B7E4EF-68A3-CBD1-8CF0-DF6500FF8D61}"/>
          </ac:picMkLst>
        </pc:picChg>
        <pc:picChg chg="add mod">
          <ac:chgData name="Elliott, Andrew" userId="57170054-896e-4a7b-99a2-5f2f342d2a77" providerId="ADAL" clId="{22A9A484-E00C-8D4C-A0A2-D8BC77375D97}" dt="2024-03-04T07:06:23.839" v="2796" actId="164"/>
          <ac:picMkLst>
            <pc:docMk/>
            <pc:sldMk cId="1371429643" sldId="263"/>
            <ac:picMk id="85" creationId="{301267D6-53B8-26C1-F07C-B10EDE6E33FE}"/>
          </ac:picMkLst>
        </pc:picChg>
        <pc:picChg chg="add mod">
          <ac:chgData name="Elliott, Andrew" userId="57170054-896e-4a7b-99a2-5f2f342d2a77" providerId="ADAL" clId="{22A9A484-E00C-8D4C-A0A2-D8BC77375D97}" dt="2024-03-04T07:06:08.515" v="2795" actId="164"/>
          <ac:picMkLst>
            <pc:docMk/>
            <pc:sldMk cId="1371429643" sldId="263"/>
            <ac:picMk id="87" creationId="{B76FC36A-8213-FB38-52A9-F9E802DB5028}"/>
          </ac:picMkLst>
        </pc:picChg>
        <pc:picChg chg="add mod">
          <ac:chgData name="Elliott, Andrew" userId="57170054-896e-4a7b-99a2-5f2f342d2a77" providerId="ADAL" clId="{22A9A484-E00C-8D4C-A0A2-D8BC77375D97}" dt="2024-03-04T07:06:08.515" v="2795" actId="164"/>
          <ac:picMkLst>
            <pc:docMk/>
            <pc:sldMk cId="1371429643" sldId="263"/>
            <ac:picMk id="89" creationId="{273BD3DC-C9CE-9F1E-6D68-526850247638}"/>
          </ac:picMkLst>
        </pc:picChg>
        <pc:picChg chg="add mod">
          <ac:chgData name="Elliott, Andrew" userId="57170054-896e-4a7b-99a2-5f2f342d2a77" providerId="ADAL" clId="{22A9A484-E00C-8D4C-A0A2-D8BC77375D97}" dt="2024-03-04T07:06:08.515" v="2795" actId="164"/>
          <ac:picMkLst>
            <pc:docMk/>
            <pc:sldMk cId="1371429643" sldId="263"/>
            <ac:picMk id="92" creationId="{FABCB076-A4EC-AD2E-ED73-8F9CC07A3DD5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93" creationId="{9EF2E122-946C-DD59-F372-E9BE46667469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94" creationId="{BCFA5A33-6D81-29D4-F0D4-ACA9271E86D7}"/>
          </ac:picMkLst>
        </pc:picChg>
        <pc:picChg chg="add del mod">
          <ac:chgData name="Elliott, Andrew" userId="57170054-896e-4a7b-99a2-5f2f342d2a77" providerId="ADAL" clId="{22A9A484-E00C-8D4C-A0A2-D8BC77375D97}" dt="2024-02-29T06:53:37.805" v="1689" actId="478"/>
          <ac:picMkLst>
            <pc:docMk/>
            <pc:sldMk cId="1371429643" sldId="263"/>
            <ac:picMk id="95" creationId="{8C41CC64-81A8-86A7-C560-8BCC9CE92508}"/>
          </ac:picMkLst>
        </pc:picChg>
        <pc:picChg chg="add mod">
          <ac:chgData name="Elliott, Andrew" userId="57170054-896e-4a7b-99a2-5f2f342d2a77" providerId="ADAL" clId="{22A9A484-E00C-8D4C-A0A2-D8BC77375D97}" dt="2024-03-04T07:05:57.155" v="2794" actId="164"/>
          <ac:picMkLst>
            <pc:docMk/>
            <pc:sldMk cId="1371429643" sldId="263"/>
            <ac:picMk id="106" creationId="{BE43AACD-BD24-670E-C754-3D249B428CEB}"/>
          </ac:picMkLst>
        </pc:picChg>
        <pc:picChg chg="add mod">
          <ac:chgData name="Elliott, Andrew" userId="57170054-896e-4a7b-99a2-5f2f342d2a77" providerId="ADAL" clId="{22A9A484-E00C-8D4C-A0A2-D8BC77375D97}" dt="2024-03-04T07:05:57.155" v="2794" actId="164"/>
          <ac:picMkLst>
            <pc:docMk/>
            <pc:sldMk cId="1371429643" sldId="263"/>
            <ac:picMk id="113" creationId="{089E6575-3BCD-2489-7564-5C00EB66B332}"/>
          </ac:picMkLst>
        </pc:picChg>
        <pc:picChg chg="add mod">
          <ac:chgData name="Elliott, Andrew" userId="57170054-896e-4a7b-99a2-5f2f342d2a77" providerId="ADAL" clId="{22A9A484-E00C-8D4C-A0A2-D8BC77375D97}" dt="2024-03-04T07:05:57.155" v="2794" actId="164"/>
          <ac:picMkLst>
            <pc:docMk/>
            <pc:sldMk cId="1371429643" sldId="263"/>
            <ac:picMk id="115" creationId="{EA8362AB-F7F1-CD11-E280-793AF7D3C127}"/>
          </ac:picMkLst>
        </pc:picChg>
        <pc:picChg chg="del">
          <ac:chgData name="Elliott, Andrew" userId="57170054-896e-4a7b-99a2-5f2f342d2a77" providerId="ADAL" clId="{22A9A484-E00C-8D4C-A0A2-D8BC77375D97}" dt="2024-02-29T01:56:01.878" v="899" actId="478"/>
          <ac:picMkLst>
            <pc:docMk/>
            <pc:sldMk cId="1371429643" sldId="263"/>
            <ac:picMk id="168" creationId="{D293DA83-AD25-E87E-289E-DF6BB9C1327B}"/>
          </ac:picMkLst>
        </pc:picChg>
        <pc:picChg chg="del">
          <ac:chgData name="Elliott, Andrew" userId="57170054-896e-4a7b-99a2-5f2f342d2a77" providerId="ADAL" clId="{22A9A484-E00C-8D4C-A0A2-D8BC77375D97}" dt="2024-02-29T01:56:01.878" v="899" actId="478"/>
          <ac:picMkLst>
            <pc:docMk/>
            <pc:sldMk cId="1371429643" sldId="263"/>
            <ac:picMk id="170" creationId="{2B0BC52C-FB5A-2802-7018-A513D0FF588F}"/>
          </ac:picMkLst>
        </pc:picChg>
        <pc:picChg chg="del mod">
          <ac:chgData name="Elliott, Andrew" userId="57170054-896e-4a7b-99a2-5f2f342d2a77" providerId="ADAL" clId="{22A9A484-E00C-8D4C-A0A2-D8BC77375D97}" dt="2024-02-29T02:00:39.370" v="910" actId="478"/>
          <ac:picMkLst>
            <pc:docMk/>
            <pc:sldMk cId="1371429643" sldId="263"/>
            <ac:picMk id="172" creationId="{C9F66E7E-6103-8D49-F813-CBCFE1959AA2}"/>
          </ac:picMkLst>
        </pc:picChg>
        <pc:picChg chg="del mod">
          <ac:chgData name="Elliott, Andrew" userId="57170054-896e-4a7b-99a2-5f2f342d2a77" providerId="ADAL" clId="{22A9A484-E00C-8D4C-A0A2-D8BC77375D97}" dt="2024-02-29T05:34:51.956" v="1109" actId="478"/>
          <ac:picMkLst>
            <pc:docMk/>
            <pc:sldMk cId="1371429643" sldId="263"/>
            <ac:picMk id="174" creationId="{7F989E68-02DA-4D82-B761-5ED7B58139DB}"/>
          </ac:picMkLst>
        </pc:picChg>
        <pc:picChg chg="del mod">
          <ac:chgData name="Elliott, Andrew" userId="57170054-896e-4a7b-99a2-5f2f342d2a77" providerId="ADAL" clId="{22A9A484-E00C-8D4C-A0A2-D8BC77375D97}" dt="2024-02-29T05:34:51.956" v="1109" actId="478"/>
          <ac:picMkLst>
            <pc:docMk/>
            <pc:sldMk cId="1371429643" sldId="263"/>
            <ac:picMk id="176" creationId="{2073ABFC-D59B-C724-3708-8266236527AB}"/>
          </ac:picMkLst>
        </pc:picChg>
        <pc:picChg chg="del mod">
          <ac:chgData name="Elliott, Andrew" userId="57170054-896e-4a7b-99a2-5f2f342d2a77" providerId="ADAL" clId="{22A9A484-E00C-8D4C-A0A2-D8BC77375D97}" dt="2024-02-29T05:34:51.956" v="1109" actId="478"/>
          <ac:picMkLst>
            <pc:docMk/>
            <pc:sldMk cId="1371429643" sldId="263"/>
            <ac:picMk id="178" creationId="{3F092377-3865-03F3-3099-2235B6DE2D2C}"/>
          </ac:picMkLst>
        </pc:picChg>
        <pc:cxnChg chg="mod topLvl">
          <ac:chgData name="Elliott, Andrew" userId="57170054-896e-4a7b-99a2-5f2f342d2a77" providerId="ADAL" clId="{22A9A484-E00C-8D4C-A0A2-D8BC77375D97}" dt="2024-03-04T06:20:37.444" v="1759" actId="1035"/>
          <ac:cxnSpMkLst>
            <pc:docMk/>
            <pc:sldMk cId="1371429643" sldId="263"/>
            <ac:cxnSpMk id="5" creationId="{C90BB6F9-93D4-26DB-8B0B-4C6DEB58B70A}"/>
          </ac:cxnSpMkLst>
        </pc:cxnChg>
      </pc:sldChg>
      <pc:sldChg chg="addSp delSp modSp mod modNotesTx">
        <pc:chgData name="Elliott, Andrew" userId="57170054-896e-4a7b-99a2-5f2f342d2a77" providerId="ADAL" clId="{22A9A484-E00C-8D4C-A0A2-D8BC77375D97}" dt="2024-02-28T05:58:39.587" v="281" actId="1076"/>
        <pc:sldMkLst>
          <pc:docMk/>
          <pc:sldMk cId="67374948" sldId="264"/>
        </pc:sldMkLst>
        <pc:spChg chg="add del mod">
          <ac:chgData name="Elliott, Andrew" userId="57170054-896e-4a7b-99a2-5f2f342d2a77" providerId="ADAL" clId="{22A9A484-E00C-8D4C-A0A2-D8BC77375D97}" dt="2024-02-28T05:35:18.480" v="10" actId="478"/>
          <ac:spMkLst>
            <pc:docMk/>
            <pc:sldMk cId="67374948" sldId="264"/>
            <ac:spMk id="6" creationId="{CC5A22F1-34A4-8987-B2FE-FCD761071742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12" creationId="{E5515DFD-AB0D-7B9D-7B3C-C11E23AB26BA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15" creationId="{AE077614-83E5-7B19-3854-2FB5536EF705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17" creationId="{B9161248-EAD1-CD7B-10CB-B75B5B7BA51F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20" creationId="{DBF9C92B-9529-699E-D737-E9D3886F76D4}"/>
          </ac:spMkLst>
        </pc:spChg>
        <pc:spChg chg="add del mod">
          <ac:chgData name="Elliott, Andrew" userId="57170054-896e-4a7b-99a2-5f2f342d2a77" providerId="ADAL" clId="{22A9A484-E00C-8D4C-A0A2-D8BC77375D97}" dt="2024-02-28T05:58:30.583" v="279" actId="478"/>
          <ac:spMkLst>
            <pc:docMk/>
            <pc:sldMk cId="67374948" sldId="264"/>
            <ac:spMk id="21" creationId="{9E97945F-A6FD-4117-D795-2B5B99C6C53D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23" creationId="{D013A243-0CA6-9C9F-C148-9822387C0A13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26" creationId="{166DD2CA-3E0A-5585-1C17-4F418B1A3BD6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30" creationId="{FA83AA41-8839-BDE0-0889-17A1EDB5BD16}"/>
          </ac:spMkLst>
        </pc:spChg>
        <pc:spChg chg="add del">
          <ac:chgData name="Elliott, Andrew" userId="57170054-896e-4a7b-99a2-5f2f342d2a77" providerId="ADAL" clId="{22A9A484-E00C-8D4C-A0A2-D8BC77375D97}" dt="2024-02-28T05:50:50.273" v="67" actId="22"/>
          <ac:spMkLst>
            <pc:docMk/>
            <pc:sldMk cId="67374948" sldId="264"/>
            <ac:spMk id="31" creationId="{23F6EDF4-FA88-EE20-BFDF-0E4C50E6936F}"/>
          </ac:spMkLst>
        </pc:spChg>
        <pc:spChg chg="add del mod">
          <ac:chgData name="Elliott, Andrew" userId="57170054-896e-4a7b-99a2-5f2f342d2a77" providerId="ADAL" clId="{22A9A484-E00C-8D4C-A0A2-D8BC77375D97}" dt="2024-02-28T05:58:30.583" v="279" actId="478"/>
          <ac:spMkLst>
            <pc:docMk/>
            <pc:sldMk cId="67374948" sldId="264"/>
            <ac:spMk id="33" creationId="{CC24DD40-552C-6EBD-7F13-FE30BE79641C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35" creationId="{7CDEE6F0-18C2-AA1D-ABC5-A2AFD18FE2C1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36" creationId="{D3376146-0565-1B6B-8956-E5A4B580E4A0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37" creationId="{75A75B6A-0FD5-1616-1095-4C3A5A07211E}"/>
          </ac:spMkLst>
        </pc:spChg>
        <pc:spChg chg="mod">
          <ac:chgData name="Elliott, Andrew" userId="57170054-896e-4a7b-99a2-5f2f342d2a77" providerId="ADAL" clId="{22A9A484-E00C-8D4C-A0A2-D8BC77375D97}" dt="2024-02-28T05:58:39.587" v="281" actId="1076"/>
          <ac:spMkLst>
            <pc:docMk/>
            <pc:sldMk cId="67374948" sldId="264"/>
            <ac:spMk id="38" creationId="{6E9B8FCD-0EB4-8638-0AAB-B143D3B332AD}"/>
          </ac:spMkLst>
        </pc:spChg>
        <pc:spChg chg="add del mod">
          <ac:chgData name="Elliott, Andrew" userId="57170054-896e-4a7b-99a2-5f2f342d2a77" providerId="ADAL" clId="{22A9A484-E00C-8D4C-A0A2-D8BC77375D97}" dt="2024-02-28T05:58:30.583" v="279" actId="478"/>
          <ac:spMkLst>
            <pc:docMk/>
            <pc:sldMk cId="67374948" sldId="264"/>
            <ac:spMk id="39" creationId="{3EB6C46A-23C3-521E-821E-513E18398867}"/>
          </ac:spMkLst>
        </pc:spChg>
        <pc:spChg chg="add del mod">
          <ac:chgData name="Elliott, Andrew" userId="57170054-896e-4a7b-99a2-5f2f342d2a77" providerId="ADAL" clId="{22A9A484-E00C-8D4C-A0A2-D8BC77375D97}" dt="2024-02-28T05:58:30.583" v="279" actId="478"/>
          <ac:spMkLst>
            <pc:docMk/>
            <pc:sldMk cId="67374948" sldId="264"/>
            <ac:spMk id="41" creationId="{8E41EBE6-C960-42FC-4388-DD1064575785}"/>
          </ac:spMkLst>
        </pc:spChg>
        <pc:spChg chg="add del mod">
          <ac:chgData name="Elliott, Andrew" userId="57170054-896e-4a7b-99a2-5f2f342d2a77" providerId="ADAL" clId="{22A9A484-E00C-8D4C-A0A2-D8BC77375D97}" dt="2024-02-28T05:58:30.583" v="279" actId="478"/>
          <ac:spMkLst>
            <pc:docMk/>
            <pc:sldMk cId="67374948" sldId="264"/>
            <ac:spMk id="42" creationId="{10A8147B-0018-D7B9-8425-0B576ACA598B}"/>
          </ac:spMkLst>
        </pc:spChg>
        <pc:spChg chg="add del mod">
          <ac:chgData name="Elliott, Andrew" userId="57170054-896e-4a7b-99a2-5f2f342d2a77" providerId="ADAL" clId="{22A9A484-E00C-8D4C-A0A2-D8BC77375D97}" dt="2024-02-28T05:58:33.011" v="280" actId="478"/>
          <ac:spMkLst>
            <pc:docMk/>
            <pc:sldMk cId="67374948" sldId="264"/>
            <ac:spMk id="43" creationId="{7A41126D-9F45-3C42-66C6-6C16CFDE6C0C}"/>
          </ac:spMkLst>
        </pc:spChg>
        <pc:graphicFrameChg chg="add mod">
          <ac:chgData name="Elliott, Andrew" userId="57170054-896e-4a7b-99a2-5f2f342d2a77" providerId="ADAL" clId="{22A9A484-E00C-8D4C-A0A2-D8BC77375D97}" dt="2024-02-28T05:35:00.681" v="3"/>
          <ac:graphicFrameMkLst>
            <pc:docMk/>
            <pc:sldMk cId="67374948" sldId="264"/>
            <ac:graphicFrameMk id="2" creationId="{554B17E4-FA9B-525E-303F-22D28E7027FE}"/>
          </ac:graphicFrameMkLst>
        </pc:graphicFrameChg>
        <pc:graphicFrameChg chg="add del mod modGraphic">
          <ac:chgData name="Elliott, Andrew" userId="57170054-896e-4a7b-99a2-5f2f342d2a77" providerId="ADAL" clId="{22A9A484-E00C-8D4C-A0A2-D8BC77375D97}" dt="2024-02-28T05:40:37.045" v="26" actId="478"/>
          <ac:graphicFrameMkLst>
            <pc:docMk/>
            <pc:sldMk cId="67374948" sldId="264"/>
            <ac:graphicFrameMk id="3" creationId="{9EB01F69-5E54-B410-B094-DA347FC8B0E5}"/>
          </ac:graphicFrameMkLst>
        </pc:graphicFrameChg>
        <pc:graphicFrameChg chg="add mod">
          <ac:chgData name="Elliott, Andrew" userId="57170054-896e-4a7b-99a2-5f2f342d2a77" providerId="ADAL" clId="{22A9A484-E00C-8D4C-A0A2-D8BC77375D97}" dt="2024-02-28T05:37:10.398" v="13"/>
          <ac:graphicFrameMkLst>
            <pc:docMk/>
            <pc:sldMk cId="67374948" sldId="264"/>
            <ac:graphicFrameMk id="8" creationId="{CE6A7EB4-AFFE-06E1-E298-679F77C75241}"/>
          </ac:graphicFrameMkLst>
        </pc:graphicFrameChg>
        <pc:graphicFrameChg chg="add mod modGraphic">
          <ac:chgData name="Elliott, Andrew" userId="57170054-896e-4a7b-99a2-5f2f342d2a77" providerId="ADAL" clId="{22A9A484-E00C-8D4C-A0A2-D8BC77375D97}" dt="2024-02-28T05:37:44.139" v="24" actId="14734"/>
          <ac:graphicFrameMkLst>
            <pc:docMk/>
            <pc:sldMk cId="67374948" sldId="264"/>
            <ac:graphicFrameMk id="10" creationId="{08028E58-83AE-6342-768B-CE0A12ECAA17}"/>
          </ac:graphicFrameMkLst>
        </pc:graphicFrameChg>
        <pc:graphicFrameChg chg="add mod">
          <ac:chgData name="Elliott, Andrew" userId="57170054-896e-4a7b-99a2-5f2f342d2a77" providerId="ADAL" clId="{22A9A484-E00C-8D4C-A0A2-D8BC77375D97}" dt="2024-02-28T05:40:37.490" v="27"/>
          <ac:graphicFrameMkLst>
            <pc:docMk/>
            <pc:sldMk cId="67374948" sldId="264"/>
            <ac:graphicFrameMk id="13" creationId="{EA98C142-4B8B-3AAB-E38D-6BEA210B3834}"/>
          </ac:graphicFrameMkLst>
        </pc:graphicFrameChg>
        <pc:graphicFrameChg chg="add del mod modGraphic">
          <ac:chgData name="Elliott, Andrew" userId="57170054-896e-4a7b-99a2-5f2f342d2a77" providerId="ADAL" clId="{22A9A484-E00C-8D4C-A0A2-D8BC77375D97}" dt="2024-02-28T05:49:39.485" v="56" actId="478"/>
          <ac:graphicFrameMkLst>
            <pc:docMk/>
            <pc:sldMk cId="67374948" sldId="264"/>
            <ac:graphicFrameMk id="18" creationId="{73A6CC9D-8F2A-25F3-78F6-CF331C46D55E}"/>
          </ac:graphicFrameMkLst>
        </pc:graphicFrameChg>
        <pc:graphicFrameChg chg="add mod">
          <ac:chgData name="Elliott, Andrew" userId="57170054-896e-4a7b-99a2-5f2f342d2a77" providerId="ADAL" clId="{22A9A484-E00C-8D4C-A0A2-D8BC77375D97}" dt="2024-02-28T05:49:01.099" v="45"/>
          <ac:graphicFrameMkLst>
            <pc:docMk/>
            <pc:sldMk cId="67374948" sldId="264"/>
            <ac:graphicFrameMk id="24" creationId="{F15E798C-24EC-0813-2799-2619A3CCEE18}"/>
          </ac:graphicFrameMkLst>
        </pc:graphicFrameChg>
        <pc:graphicFrameChg chg="add del mod modGraphic">
          <ac:chgData name="Elliott, Andrew" userId="57170054-896e-4a7b-99a2-5f2f342d2a77" providerId="ADAL" clId="{22A9A484-E00C-8D4C-A0A2-D8BC77375D97}" dt="2024-02-28T05:58:30.583" v="279" actId="478"/>
          <ac:graphicFrameMkLst>
            <pc:docMk/>
            <pc:sldMk cId="67374948" sldId="264"/>
            <ac:graphicFrameMk id="27" creationId="{704C1C58-680B-8C9A-62B9-578798D0BC14}"/>
          </ac:graphicFrameMkLst>
        </pc:graphicFrameChg>
        <pc:picChg chg="add del mod">
          <ac:chgData name="Elliott, Andrew" userId="57170054-896e-4a7b-99a2-5f2f342d2a77" providerId="ADAL" clId="{22A9A484-E00C-8D4C-A0A2-D8BC77375D97}" dt="2024-02-28T05:37:47.720" v="25" actId="478"/>
          <ac:picMkLst>
            <pc:docMk/>
            <pc:sldMk cId="67374948" sldId="264"/>
            <ac:picMk id="5" creationId="{0F45CD51-80B2-477F-E608-A880280706C5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7" creationId="{52015FA6-A52E-F64D-45A1-70D448EC231B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9" creationId="{4266AE1B-207D-FB67-DD48-8D692EFE20C2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11" creationId="{0F7DE02C-462D-3752-E02C-A0CD7EEE6610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14" creationId="{4506F15D-DBDF-22C5-AE68-4839C6AE9BFF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16" creationId="{F454179F-085C-CDE8-2B1E-06224C935BDC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19" creationId="{AAE0BE7A-3D2C-9F67-39F2-DB7E61AAEAF4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22" creationId="{90465D9F-B680-6BD9-56DA-25A2B6135E7D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25" creationId="{91F97AC3-E6F5-6426-E407-4CCB41378C26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29" creationId="{91B4467C-32B9-C27D-5422-7E0FE9DA33D7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32" creationId="{C1DE62DB-D913-6747-9126-CDD7EFFE83CD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34" creationId="{1D3661E6-C834-8800-DA76-4238E209F2B0}"/>
          </ac:picMkLst>
        </pc:picChg>
        <pc:picChg chg="mod">
          <ac:chgData name="Elliott, Andrew" userId="57170054-896e-4a7b-99a2-5f2f342d2a77" providerId="ADAL" clId="{22A9A484-E00C-8D4C-A0A2-D8BC77375D97}" dt="2024-02-28T05:58:39.587" v="281" actId="1076"/>
          <ac:picMkLst>
            <pc:docMk/>
            <pc:sldMk cId="67374948" sldId="264"/>
            <ac:picMk id="40" creationId="{F1E27439-3275-7252-7FE9-9E6EABFAB25E}"/>
          </ac:picMkLst>
        </pc:picChg>
      </pc:sldChg>
      <pc:sldChg chg="delSp modSp add mod">
        <pc:chgData name="Elliott, Andrew" userId="57170054-896e-4a7b-99a2-5f2f342d2a77" providerId="ADAL" clId="{22A9A484-E00C-8D4C-A0A2-D8BC77375D97}" dt="2024-02-28T17:03:33.262" v="510"/>
        <pc:sldMkLst>
          <pc:docMk/>
          <pc:sldMk cId="2467534146" sldId="265"/>
        </pc:sldMkLst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12" creationId="{E5515DFD-AB0D-7B9D-7B3C-C11E23AB26BA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15" creationId="{AE077614-83E5-7B19-3854-2FB5536EF705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17" creationId="{B9161248-EAD1-CD7B-10CB-B75B5B7BA51F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20" creationId="{DBF9C92B-9529-699E-D737-E9D3886F76D4}"/>
          </ac:spMkLst>
        </pc:spChg>
        <pc:spChg chg="mod">
          <ac:chgData name="Elliott, Andrew" userId="57170054-896e-4a7b-99a2-5f2f342d2a77" providerId="ADAL" clId="{22A9A484-E00C-8D4C-A0A2-D8BC77375D97}" dt="2024-02-28T05:58:26.029" v="278" actId="1076"/>
          <ac:spMkLst>
            <pc:docMk/>
            <pc:sldMk cId="2467534146" sldId="265"/>
            <ac:spMk id="21" creationId="{9E97945F-A6FD-4117-D795-2B5B99C6C53D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23" creationId="{D013A243-0CA6-9C9F-C148-9822387C0A13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26" creationId="{166DD2CA-3E0A-5585-1C17-4F418B1A3BD6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30" creationId="{FA83AA41-8839-BDE0-0889-17A1EDB5BD16}"/>
          </ac:spMkLst>
        </pc:spChg>
        <pc:spChg chg="mod">
          <ac:chgData name="Elliott, Andrew" userId="57170054-896e-4a7b-99a2-5f2f342d2a77" providerId="ADAL" clId="{22A9A484-E00C-8D4C-A0A2-D8BC77375D97}" dt="2024-02-28T17:03:33.262" v="510"/>
          <ac:spMkLst>
            <pc:docMk/>
            <pc:sldMk cId="2467534146" sldId="265"/>
            <ac:spMk id="33" creationId="{CC24DD40-552C-6EBD-7F13-FE30BE79641C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35" creationId="{7CDEE6F0-18C2-AA1D-ABC5-A2AFD18FE2C1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36" creationId="{D3376146-0565-1B6B-8956-E5A4B580E4A0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37" creationId="{75A75B6A-0FD5-1616-1095-4C3A5A07211E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38" creationId="{6E9B8FCD-0EB4-8638-0AAB-B143D3B332AD}"/>
          </ac:spMkLst>
        </pc:spChg>
        <pc:spChg chg="mod">
          <ac:chgData name="Elliott, Andrew" userId="57170054-896e-4a7b-99a2-5f2f342d2a77" providerId="ADAL" clId="{22A9A484-E00C-8D4C-A0A2-D8BC77375D97}" dt="2024-02-28T05:58:26.029" v="278" actId="1076"/>
          <ac:spMkLst>
            <pc:docMk/>
            <pc:sldMk cId="2467534146" sldId="265"/>
            <ac:spMk id="39" creationId="{3EB6C46A-23C3-521E-821E-513E18398867}"/>
          </ac:spMkLst>
        </pc:spChg>
        <pc:spChg chg="mod">
          <ac:chgData name="Elliott, Andrew" userId="57170054-896e-4a7b-99a2-5f2f342d2a77" providerId="ADAL" clId="{22A9A484-E00C-8D4C-A0A2-D8BC77375D97}" dt="2024-02-28T05:58:26.029" v="278" actId="1076"/>
          <ac:spMkLst>
            <pc:docMk/>
            <pc:sldMk cId="2467534146" sldId="265"/>
            <ac:spMk id="41" creationId="{8E41EBE6-C960-42FC-4388-DD1064575785}"/>
          </ac:spMkLst>
        </pc:spChg>
        <pc:spChg chg="mod">
          <ac:chgData name="Elliott, Andrew" userId="57170054-896e-4a7b-99a2-5f2f342d2a77" providerId="ADAL" clId="{22A9A484-E00C-8D4C-A0A2-D8BC77375D97}" dt="2024-02-28T05:58:26.029" v="278" actId="1076"/>
          <ac:spMkLst>
            <pc:docMk/>
            <pc:sldMk cId="2467534146" sldId="265"/>
            <ac:spMk id="42" creationId="{10A8147B-0018-D7B9-8425-0B576ACA598B}"/>
          </ac:spMkLst>
        </pc:spChg>
        <pc:spChg chg="del">
          <ac:chgData name="Elliott, Andrew" userId="57170054-896e-4a7b-99a2-5f2f342d2a77" providerId="ADAL" clId="{22A9A484-E00C-8D4C-A0A2-D8BC77375D97}" dt="2024-02-28T05:58:15.802" v="276" actId="478"/>
          <ac:spMkLst>
            <pc:docMk/>
            <pc:sldMk cId="2467534146" sldId="265"/>
            <ac:spMk id="43" creationId="{7A41126D-9F45-3C42-66C6-6C16CFDE6C0C}"/>
          </ac:spMkLst>
        </pc:spChg>
        <pc:graphicFrameChg chg="mod modGraphic">
          <ac:chgData name="Elliott, Andrew" userId="57170054-896e-4a7b-99a2-5f2f342d2a77" providerId="ADAL" clId="{22A9A484-E00C-8D4C-A0A2-D8BC77375D97}" dt="2024-02-28T16:45:59.018" v="508" actId="20577"/>
          <ac:graphicFrameMkLst>
            <pc:docMk/>
            <pc:sldMk cId="2467534146" sldId="265"/>
            <ac:graphicFrameMk id="27" creationId="{704C1C58-680B-8C9A-62B9-578798D0BC14}"/>
          </ac:graphicFrameMkLst>
        </pc:graphicFrame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7" creationId="{52015FA6-A52E-F64D-45A1-70D448EC231B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9" creationId="{4266AE1B-207D-FB67-DD48-8D692EFE20C2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11" creationId="{0F7DE02C-462D-3752-E02C-A0CD7EEE6610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14" creationId="{4506F15D-DBDF-22C5-AE68-4839C6AE9BFF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16" creationId="{F454179F-085C-CDE8-2B1E-06224C935BDC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19" creationId="{AAE0BE7A-3D2C-9F67-39F2-DB7E61AAEAF4}"/>
          </ac:picMkLst>
        </pc:picChg>
        <pc:picChg chg="del">
          <ac:chgData name="Elliott, Andrew" userId="57170054-896e-4a7b-99a2-5f2f342d2a77" providerId="ADAL" clId="{22A9A484-E00C-8D4C-A0A2-D8BC77375D97}" dt="2024-02-28T05:58:18.270" v="277" actId="478"/>
          <ac:picMkLst>
            <pc:docMk/>
            <pc:sldMk cId="2467534146" sldId="265"/>
            <ac:picMk id="22" creationId="{90465D9F-B680-6BD9-56DA-25A2B6135E7D}"/>
          </ac:picMkLst>
        </pc:picChg>
        <pc:picChg chg="del">
          <ac:chgData name="Elliott, Andrew" userId="57170054-896e-4a7b-99a2-5f2f342d2a77" providerId="ADAL" clId="{22A9A484-E00C-8D4C-A0A2-D8BC77375D97}" dt="2024-02-28T05:58:18.270" v="277" actId="478"/>
          <ac:picMkLst>
            <pc:docMk/>
            <pc:sldMk cId="2467534146" sldId="265"/>
            <ac:picMk id="25" creationId="{91F97AC3-E6F5-6426-E407-4CCB41378C26}"/>
          </ac:picMkLst>
        </pc:picChg>
        <pc:picChg chg="del">
          <ac:chgData name="Elliott, Andrew" userId="57170054-896e-4a7b-99a2-5f2f342d2a77" providerId="ADAL" clId="{22A9A484-E00C-8D4C-A0A2-D8BC77375D97}" dt="2024-02-28T05:58:18.270" v="277" actId="478"/>
          <ac:picMkLst>
            <pc:docMk/>
            <pc:sldMk cId="2467534146" sldId="265"/>
            <ac:picMk id="29" creationId="{91B4467C-32B9-C27D-5422-7E0FE9DA33D7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32" creationId="{C1DE62DB-D913-6747-9126-CDD7EFFE83CD}"/>
          </ac:picMkLst>
        </pc:picChg>
        <pc:picChg chg="del">
          <ac:chgData name="Elliott, Andrew" userId="57170054-896e-4a7b-99a2-5f2f342d2a77" providerId="ADAL" clId="{22A9A484-E00C-8D4C-A0A2-D8BC77375D97}" dt="2024-02-28T05:58:15.802" v="276" actId="478"/>
          <ac:picMkLst>
            <pc:docMk/>
            <pc:sldMk cId="2467534146" sldId="265"/>
            <ac:picMk id="34" creationId="{1D3661E6-C834-8800-DA76-4238E209F2B0}"/>
          </ac:picMkLst>
        </pc:picChg>
        <pc:picChg chg="del">
          <ac:chgData name="Elliott, Andrew" userId="57170054-896e-4a7b-99a2-5f2f342d2a77" providerId="ADAL" clId="{22A9A484-E00C-8D4C-A0A2-D8BC77375D97}" dt="2024-02-28T05:58:18.270" v="277" actId="478"/>
          <ac:picMkLst>
            <pc:docMk/>
            <pc:sldMk cId="2467534146" sldId="265"/>
            <ac:picMk id="40" creationId="{F1E27439-3275-7252-7FE9-9E6EABFAB25E}"/>
          </ac:picMkLst>
        </pc:picChg>
      </pc:sldChg>
      <pc:sldChg chg="addSp delSp modSp new mod">
        <pc:chgData name="Elliott, Andrew" userId="57170054-896e-4a7b-99a2-5f2f342d2a77" providerId="ADAL" clId="{22A9A484-E00C-8D4C-A0A2-D8BC77375D97}" dt="2024-03-04T06:13:10.215" v="1716" actId="1076"/>
        <pc:sldMkLst>
          <pc:docMk/>
          <pc:sldMk cId="2304765057" sldId="266"/>
        </pc:sldMkLst>
        <pc:spChg chg="del">
          <ac:chgData name="Elliott, Andrew" userId="57170054-896e-4a7b-99a2-5f2f342d2a77" providerId="ADAL" clId="{22A9A484-E00C-8D4C-A0A2-D8BC77375D97}" dt="2024-02-28T06:01:22.886" v="302" actId="478"/>
          <ac:spMkLst>
            <pc:docMk/>
            <pc:sldMk cId="2304765057" sldId="266"/>
            <ac:spMk id="2" creationId="{5E978D65-38C6-EAA3-AECD-552D682DB399}"/>
          </ac:spMkLst>
        </pc:spChg>
        <pc:spChg chg="del">
          <ac:chgData name="Elliott, Andrew" userId="57170054-896e-4a7b-99a2-5f2f342d2a77" providerId="ADAL" clId="{22A9A484-E00C-8D4C-A0A2-D8BC77375D97}" dt="2024-02-28T06:01:22.886" v="302" actId="478"/>
          <ac:spMkLst>
            <pc:docMk/>
            <pc:sldMk cId="2304765057" sldId="266"/>
            <ac:spMk id="3" creationId="{5ADC1EEF-55BB-0CEA-31F8-26B48F0EFDCC}"/>
          </ac:spMkLst>
        </pc:spChg>
        <pc:spChg chg="add mod">
          <ac:chgData name="Elliott, Andrew" userId="57170054-896e-4a7b-99a2-5f2f342d2a77" providerId="ADAL" clId="{22A9A484-E00C-8D4C-A0A2-D8BC77375D97}" dt="2024-02-28T16:27:43.419" v="392" actId="20577"/>
          <ac:spMkLst>
            <pc:docMk/>
            <pc:sldMk cId="2304765057" sldId="266"/>
            <ac:spMk id="6" creationId="{BEB295E3-6C05-E792-ADD3-3E38420D959A}"/>
          </ac:spMkLst>
        </pc:spChg>
        <pc:spChg chg="add mod">
          <ac:chgData name="Elliott, Andrew" userId="57170054-896e-4a7b-99a2-5f2f342d2a77" providerId="ADAL" clId="{22A9A484-E00C-8D4C-A0A2-D8BC77375D97}" dt="2024-02-28T16:27:45.519" v="393" actId="20577"/>
          <ac:spMkLst>
            <pc:docMk/>
            <pc:sldMk cId="2304765057" sldId="266"/>
            <ac:spMk id="7" creationId="{9908DBC6-1EE2-C5C4-DB42-1590A8F700EE}"/>
          </ac:spMkLst>
        </pc:spChg>
        <pc:picChg chg="add mod">
          <ac:chgData name="Elliott, Andrew" userId="57170054-896e-4a7b-99a2-5f2f342d2a77" providerId="ADAL" clId="{22A9A484-E00C-8D4C-A0A2-D8BC77375D97}" dt="2024-03-04T06:12:56.776" v="1714" actId="1076"/>
          <ac:picMkLst>
            <pc:docMk/>
            <pc:sldMk cId="2304765057" sldId="266"/>
            <ac:picMk id="2" creationId="{DA39267E-7B7A-E4F9-8259-40B1DE6751AF}"/>
          </ac:picMkLst>
        </pc:picChg>
        <pc:picChg chg="add mod">
          <ac:chgData name="Elliott, Andrew" userId="57170054-896e-4a7b-99a2-5f2f342d2a77" providerId="ADAL" clId="{22A9A484-E00C-8D4C-A0A2-D8BC77375D97}" dt="2024-03-04T06:13:10.215" v="1716" actId="1076"/>
          <ac:picMkLst>
            <pc:docMk/>
            <pc:sldMk cId="2304765057" sldId="266"/>
            <ac:picMk id="3" creationId="{25501655-E0C4-A888-ECF8-D60F5A21090F}"/>
          </ac:picMkLst>
        </pc:picChg>
        <pc:picChg chg="add del mod">
          <ac:chgData name="Elliott, Andrew" userId="57170054-896e-4a7b-99a2-5f2f342d2a77" providerId="ADAL" clId="{22A9A484-E00C-8D4C-A0A2-D8BC77375D97}" dt="2024-02-28T22:42:57.861" v="515" actId="478"/>
          <ac:picMkLst>
            <pc:docMk/>
            <pc:sldMk cId="2304765057" sldId="266"/>
            <ac:picMk id="4" creationId="{6E68D0E0-061C-BABE-CA79-71C914AC7C0B}"/>
          </ac:picMkLst>
        </pc:picChg>
        <pc:picChg chg="add del mod">
          <ac:chgData name="Elliott, Andrew" userId="57170054-896e-4a7b-99a2-5f2f342d2a77" providerId="ADAL" clId="{22A9A484-E00C-8D4C-A0A2-D8BC77375D97}" dt="2024-02-28T22:42:15.769" v="512" actId="478"/>
          <ac:picMkLst>
            <pc:docMk/>
            <pc:sldMk cId="2304765057" sldId="266"/>
            <ac:picMk id="5" creationId="{42998794-C0B0-900F-0FA3-2B3E4E51530B}"/>
          </ac:picMkLst>
        </pc:picChg>
        <pc:picChg chg="add del mod">
          <ac:chgData name="Elliott, Andrew" userId="57170054-896e-4a7b-99a2-5f2f342d2a77" providerId="ADAL" clId="{22A9A484-E00C-8D4C-A0A2-D8BC77375D97}" dt="2024-03-04T06:12:41.213" v="1711" actId="478"/>
          <ac:picMkLst>
            <pc:docMk/>
            <pc:sldMk cId="2304765057" sldId="266"/>
            <ac:picMk id="8" creationId="{6C01E85E-0223-A123-09E6-E7466F88300A}"/>
          </ac:picMkLst>
        </pc:picChg>
        <pc:picChg chg="add del mod">
          <ac:chgData name="Elliott, Andrew" userId="57170054-896e-4a7b-99a2-5f2f342d2a77" providerId="ADAL" clId="{22A9A484-E00C-8D4C-A0A2-D8BC77375D97}" dt="2024-03-04T06:12:41.213" v="1711" actId="478"/>
          <ac:picMkLst>
            <pc:docMk/>
            <pc:sldMk cId="2304765057" sldId="266"/>
            <ac:picMk id="9" creationId="{42F484E7-D45A-3F51-DC45-50AC41557487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68E74BE-DE6D-C34A-9276-F0512E35AA22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7D71CD-299B-EF44-8783-6F62CD3E40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2051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0683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598945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6242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42599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4472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59223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9472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39444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718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267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364534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C5244-F8DC-B543-B35C-52E8D6A9ECC0}" type="datetimeFigureOut">
              <a:rPr lang="en-US" smtClean="0"/>
              <a:t>5/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6DDE430-6736-2C42-812F-F63E42B7672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76512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EB295E3-6C05-E792-ADD3-3E38420D959A}"/>
              </a:ext>
            </a:extLst>
          </p:cNvPr>
          <p:cNvSpPr txBox="1"/>
          <p:nvPr/>
        </p:nvSpPr>
        <p:spPr>
          <a:xfrm>
            <a:off x="2028373" y="474414"/>
            <a:ext cx="28750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D276 by Age (&gt;/&lt; 65 years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908DBC6-1EE2-C5C4-DB42-1590A8F700EE}"/>
              </a:ext>
            </a:extLst>
          </p:cNvPr>
          <p:cNvSpPr txBox="1"/>
          <p:nvPr/>
        </p:nvSpPr>
        <p:spPr>
          <a:xfrm>
            <a:off x="2899230" y="4235630"/>
            <a:ext cx="14670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/>
              <a:t>CD276 by Sex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DA39267E-7B7A-E4F9-8259-40B1DE6751A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604962"/>
            <a:ext cx="6858000" cy="2991130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5501655-E0C4-A888-ECF8-D60F5A21090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854220"/>
            <a:ext cx="6858000" cy="2991130"/>
          </a:xfrm>
          <a:prstGeom prst="rect">
            <a:avLst/>
          </a:prstGeom>
        </p:spPr>
      </p:pic>
      <p:sp>
        <p:nvSpPr>
          <p:cNvPr id="4" name="Google Shape;140;p2">
            <a:extLst>
              <a:ext uri="{FF2B5EF4-FFF2-40B4-BE49-F238E27FC236}">
                <a16:creationId xmlns:a16="http://schemas.microsoft.com/office/drawing/2014/main" id="{C1E19239-7C36-7736-5B05-EA515C29E577}"/>
              </a:ext>
            </a:extLst>
          </p:cNvPr>
          <p:cNvSpPr txBox="1"/>
          <p:nvPr/>
        </p:nvSpPr>
        <p:spPr>
          <a:xfrm>
            <a:off x="3822700" y="7861612"/>
            <a:ext cx="3035300" cy="46162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24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upplemental Figure 1</a:t>
            </a:r>
            <a:endParaRPr b="1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5" name="Google Shape;90;p1">
            <a:extLst>
              <a:ext uri="{FF2B5EF4-FFF2-40B4-BE49-F238E27FC236}">
                <a16:creationId xmlns:a16="http://schemas.microsoft.com/office/drawing/2014/main" id="{180C742E-13E7-3CDD-AFBD-C81B19BB23FE}"/>
              </a:ext>
            </a:extLst>
          </p:cNvPr>
          <p:cNvSpPr txBox="1"/>
          <p:nvPr/>
        </p:nvSpPr>
        <p:spPr>
          <a:xfrm>
            <a:off x="154511" y="3748123"/>
            <a:ext cx="351378" cy="5847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3200" b="1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</a:t>
            </a:r>
            <a:endParaRPr sz="2400" b="0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8" name="Google Shape;90;p1">
            <a:extLst>
              <a:ext uri="{FF2B5EF4-FFF2-40B4-BE49-F238E27FC236}">
                <a16:creationId xmlns:a16="http://schemas.microsoft.com/office/drawing/2014/main" id="{7FD6B57D-EC9B-7939-4BB7-41D3BED5815B}"/>
              </a:ext>
            </a:extLst>
          </p:cNvPr>
          <p:cNvSpPr txBox="1"/>
          <p:nvPr/>
        </p:nvSpPr>
        <p:spPr>
          <a:xfrm>
            <a:off x="154511" y="5468"/>
            <a:ext cx="351378" cy="58473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800"/>
              <a:buFont typeface="Arial"/>
              <a:buNone/>
            </a:pPr>
            <a:r>
              <a:rPr lang="en-US" sz="3200" b="1" i="0" u="none" strike="noStrike" cap="none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A</a:t>
            </a:r>
            <a:endParaRPr sz="2400" b="0" i="0" u="none" strike="noStrike" cap="none" dirty="0">
              <a:solidFill>
                <a:srgbClr val="000000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230476505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8D69CFB-EF6D-1F7D-4865-15D690B6A6E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631492"/>
            <a:ext cx="5915025" cy="5801784"/>
          </a:xfrm>
        </p:spPr>
        <p:txBody>
          <a:bodyPr/>
          <a:lstStyle/>
          <a:p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upplemental Figure 1. 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Characterization of CD276 mRNA expression across cancers by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A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ge (&gt; or &lt; 65 years old) and by </a:t>
            </a:r>
            <a:r>
              <a:rPr lang="en-US" sz="1800" b="1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(B)</a:t>
            </a:r>
            <a:r>
              <a:rPr lang="en-US" sz="18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sex (male or female). Data shown in violin plots in which the white dot represents the median and the black box shows the ends of the first and third quartiles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7604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296</TotalTime>
  <Words>76</Words>
  <Application>Microsoft Office PowerPoint</Application>
  <PresentationFormat>On-screen Show (4:3)</PresentationFormat>
  <Paragraphs>6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lison M Makovec</dc:creator>
  <cp:lastModifiedBy>Rekstis, Charley</cp:lastModifiedBy>
  <cp:revision>54</cp:revision>
  <dcterms:created xsi:type="dcterms:W3CDTF">2023-08-25T17:50:53Z</dcterms:created>
  <dcterms:modified xsi:type="dcterms:W3CDTF">2024-05-01T14:06:38Z</dcterms:modified>
</cp:coreProperties>
</file>